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116" d="100"/>
          <a:sy n="116" d="100"/>
        </p:scale>
        <p:origin x="8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iagrams/_rels/data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sv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svg"/><Relationship Id="rId1" Type="http://schemas.openxmlformats.org/officeDocument/2006/relationships/image" Target="../media/image5.png"/><Relationship Id="rId6" Type="http://schemas.openxmlformats.org/officeDocument/2006/relationships/image" Target="../media/image10.svg"/><Relationship Id="rId5" Type="http://schemas.openxmlformats.org/officeDocument/2006/relationships/image" Target="../media/image9.png"/><Relationship Id="rId4" Type="http://schemas.openxmlformats.org/officeDocument/2006/relationships/image" Target="../media/image8.svg"/></Relationships>
</file>

<file path=ppt/diagrams/_rels/data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svg"/><Relationship Id="rId1" Type="http://schemas.openxmlformats.org/officeDocument/2006/relationships/image" Target="../media/image13.png"/><Relationship Id="rId6" Type="http://schemas.openxmlformats.org/officeDocument/2006/relationships/image" Target="../media/image18.svg"/><Relationship Id="rId5" Type="http://schemas.openxmlformats.org/officeDocument/2006/relationships/image" Target="../media/image17.png"/><Relationship Id="rId4" Type="http://schemas.openxmlformats.org/officeDocument/2006/relationships/image" Target="../media/image16.svg"/></Relationships>
</file>

<file path=ppt/diagrams/_rels/drawing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sv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svg"/><Relationship Id="rId1" Type="http://schemas.openxmlformats.org/officeDocument/2006/relationships/image" Target="../media/image5.png"/><Relationship Id="rId6" Type="http://schemas.openxmlformats.org/officeDocument/2006/relationships/image" Target="../media/image10.svg"/><Relationship Id="rId5" Type="http://schemas.openxmlformats.org/officeDocument/2006/relationships/image" Target="../media/image9.png"/><Relationship Id="rId4" Type="http://schemas.openxmlformats.org/officeDocument/2006/relationships/image" Target="../media/image8.svg"/></Relationships>
</file>

<file path=ppt/diagrams/_rels/drawing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svg"/><Relationship Id="rId1" Type="http://schemas.openxmlformats.org/officeDocument/2006/relationships/image" Target="../media/image13.png"/><Relationship Id="rId6" Type="http://schemas.openxmlformats.org/officeDocument/2006/relationships/image" Target="../media/image18.svg"/><Relationship Id="rId5" Type="http://schemas.openxmlformats.org/officeDocument/2006/relationships/image" Target="../media/image17.png"/><Relationship Id="rId4" Type="http://schemas.openxmlformats.org/officeDocument/2006/relationships/image" Target="../media/image16.svg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18/5/colors/Iconchunking_neutralicontext_colorful1">
  <dgm:title val=""/>
  <dgm:desc val=""/>
  <dgm:catLst>
    <dgm:cat type="colorful" pri="101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bg1"/>
    </dgm:fillClrLst>
    <dgm:linClrLst meth="repeat">
      <a:schemeClr val="lt1">
        <a:alpha val="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/>
    <dgm:txEffectClrLst/>
  </dgm:styleLbl>
  <dgm:styleLbl name="l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2">
        <a:alpha val="50000"/>
      </a:schemeClr>
      <a:schemeClr val="accent3">
        <a:alpha val="50000"/>
      </a:schemeClr>
      <a:schemeClr val="accent4">
        <a:alpha val="50000"/>
      </a:schemeClr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2">
        <a:tint val="50000"/>
      </a:schemeClr>
      <a:schemeClr val="accent3">
        <a:tint val="50000"/>
      </a:schemeClr>
      <a:schemeClr val="accent4">
        <a:tint val="50000"/>
      </a:schemeClr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/>
    <dgm:txEffectClrLst/>
  </dgm:styleLbl>
  <dgm:styleLbl name="f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3">
        <a:tint val="9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>
        <a:tint val="5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>
        <a:alpha val="0"/>
      </a:schemeClr>
    </dgm:linClrLst>
    <dgm:effectClrLst/>
    <dgm:txLinClrLst/>
    <dgm:txFillClrLst/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bg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EC873A8B-4FC7-4A4D-9CE2-6E013DCD4259}" type="doc">
      <dgm:prSet loTypeId="urn:microsoft.com/office/officeart/2018/2/layout/IconVerticalSolidList" loCatId="icon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F96C327F-5DCC-4852-8530-66D5CD830068}">
      <dgm:prSet/>
      <dgm:spPr/>
      <dgm:t>
        <a:bodyPr/>
        <a:lstStyle/>
        <a:p>
          <a:pPr>
            <a:lnSpc>
              <a:spcPct val="100000"/>
            </a:lnSpc>
          </a:pPr>
          <a:r>
            <a:rPr lang="en-US" dirty="0"/>
            <a:t>You’ll receive a “Route Info Clue” to start, directing you to one of two Detour Locations. </a:t>
          </a:r>
        </a:p>
      </dgm:t>
    </dgm:pt>
    <dgm:pt modelId="{C539C78D-F238-45CF-A693-B539A0DBA9C3}" type="parTrans" cxnId="{AE96FA1A-9E3C-4A92-BF06-E422A7946562}">
      <dgm:prSet/>
      <dgm:spPr/>
      <dgm:t>
        <a:bodyPr/>
        <a:lstStyle/>
        <a:p>
          <a:endParaRPr lang="en-US"/>
        </a:p>
      </dgm:t>
    </dgm:pt>
    <dgm:pt modelId="{4A8C7ADC-6E5C-4419-834C-BFDE9422A449}" type="sibTrans" cxnId="{AE96FA1A-9E3C-4A92-BF06-E422A7946562}">
      <dgm:prSet/>
      <dgm:spPr/>
      <dgm:t>
        <a:bodyPr/>
        <a:lstStyle/>
        <a:p>
          <a:endParaRPr lang="en-US"/>
        </a:p>
      </dgm:t>
    </dgm:pt>
    <dgm:pt modelId="{3B108CB1-1F70-4884-B3B9-CB3A14559954}">
      <dgm:prSet/>
      <dgm:spPr/>
      <dgm:t>
        <a:bodyPr/>
        <a:lstStyle/>
        <a:p>
          <a:pPr>
            <a:lnSpc>
              <a:spcPct val="100000"/>
            </a:lnSpc>
          </a:pPr>
          <a:r>
            <a:rPr lang="en-US" dirty="0"/>
            <a:t>At your Detour Location, your team will receive another envelope containing “Detour Tasks”. These are two tasks that must be completed as a group. Successful completion earns you an envelope containing another “Route Info Clue” which leads to the next leg…the Roadblock</a:t>
          </a:r>
        </a:p>
      </dgm:t>
    </dgm:pt>
    <dgm:pt modelId="{45BEC6F0-37FE-4797-A05D-6E1170BF0647}" type="parTrans" cxnId="{40C0DCE1-BE08-44C1-88DD-7326C96E2BE5}">
      <dgm:prSet/>
      <dgm:spPr/>
      <dgm:t>
        <a:bodyPr/>
        <a:lstStyle/>
        <a:p>
          <a:endParaRPr lang="en-US"/>
        </a:p>
      </dgm:t>
    </dgm:pt>
    <dgm:pt modelId="{73A79510-5290-44B7-8AD4-8DC4F44C9FC4}" type="sibTrans" cxnId="{40C0DCE1-BE08-44C1-88DD-7326C96E2BE5}">
      <dgm:prSet/>
      <dgm:spPr/>
      <dgm:t>
        <a:bodyPr/>
        <a:lstStyle/>
        <a:p>
          <a:endParaRPr lang="en-US"/>
        </a:p>
      </dgm:t>
    </dgm:pt>
    <dgm:pt modelId="{A5E2CC43-816C-4A86-B938-23ED4C4DC658}">
      <dgm:prSet/>
      <dgm:spPr/>
      <dgm:t>
        <a:bodyPr/>
        <a:lstStyle/>
        <a:p>
          <a:pPr>
            <a:lnSpc>
              <a:spcPct val="100000"/>
            </a:lnSpc>
          </a:pPr>
          <a:r>
            <a:rPr lang="en-US" dirty="0"/>
            <a:t>At the Roadblock location, you’ll receive a new envelope containing a “Roadblock Task”. Your team will select one team member to complete a task alone while the rest of your team completes a different task. Successful completion of both tasks provides you with a final envelope containing a “Route Info clue” leading to the last location and victory</a:t>
          </a:r>
        </a:p>
      </dgm:t>
    </dgm:pt>
    <dgm:pt modelId="{B51B5FD9-CECD-45D6-A8C9-E0730D2E69B2}" type="parTrans" cxnId="{38B0A304-CFA5-4E55-9CC9-C5CFC28485F2}">
      <dgm:prSet/>
      <dgm:spPr/>
      <dgm:t>
        <a:bodyPr/>
        <a:lstStyle/>
        <a:p>
          <a:endParaRPr lang="en-US"/>
        </a:p>
      </dgm:t>
    </dgm:pt>
    <dgm:pt modelId="{B6F0320D-6CE1-4C1E-9497-BCFDF8C649A0}" type="sibTrans" cxnId="{38B0A304-CFA5-4E55-9CC9-C5CFC28485F2}">
      <dgm:prSet/>
      <dgm:spPr/>
      <dgm:t>
        <a:bodyPr/>
        <a:lstStyle/>
        <a:p>
          <a:endParaRPr lang="en-US"/>
        </a:p>
      </dgm:t>
    </dgm:pt>
    <dgm:pt modelId="{A79E01CC-5586-4E82-B37B-BF75DB08ECEF}">
      <dgm:prSet/>
      <dgm:spPr/>
      <dgm:t>
        <a:bodyPr/>
        <a:lstStyle/>
        <a:p>
          <a:pPr>
            <a:lnSpc>
              <a:spcPct val="100000"/>
            </a:lnSpc>
          </a:pPr>
          <a:r>
            <a:rPr lang="en-US"/>
            <a:t>Fastest team wins!</a:t>
          </a:r>
        </a:p>
      </dgm:t>
    </dgm:pt>
    <dgm:pt modelId="{D7FF57DC-3C67-4796-A6E2-01BE9F6B5D22}" type="parTrans" cxnId="{5C14BB80-B21B-46FD-95C3-85B70E72CA66}">
      <dgm:prSet/>
      <dgm:spPr/>
      <dgm:t>
        <a:bodyPr/>
        <a:lstStyle/>
        <a:p>
          <a:endParaRPr lang="en-US"/>
        </a:p>
      </dgm:t>
    </dgm:pt>
    <dgm:pt modelId="{BC3E522D-9BB0-4FE6-A9D5-4FD9049BF023}" type="sibTrans" cxnId="{5C14BB80-B21B-46FD-95C3-85B70E72CA66}">
      <dgm:prSet/>
      <dgm:spPr/>
      <dgm:t>
        <a:bodyPr/>
        <a:lstStyle/>
        <a:p>
          <a:endParaRPr lang="en-US"/>
        </a:p>
      </dgm:t>
    </dgm:pt>
    <dgm:pt modelId="{E3C55A0E-10C9-4031-A4DE-0BC83EBE64D0}" type="pres">
      <dgm:prSet presAssocID="{EC873A8B-4FC7-4A4D-9CE2-6E013DCD4259}" presName="root" presStyleCnt="0">
        <dgm:presLayoutVars>
          <dgm:dir/>
          <dgm:resizeHandles val="exact"/>
        </dgm:presLayoutVars>
      </dgm:prSet>
      <dgm:spPr/>
    </dgm:pt>
    <dgm:pt modelId="{85246EB4-2673-48A3-8677-4C1D9B90BC17}" type="pres">
      <dgm:prSet presAssocID="{F96C327F-5DCC-4852-8530-66D5CD830068}" presName="compNode" presStyleCnt="0"/>
      <dgm:spPr/>
    </dgm:pt>
    <dgm:pt modelId="{A27E8B20-6014-42AB-9E91-B6A44F4A0D04}" type="pres">
      <dgm:prSet presAssocID="{F96C327F-5DCC-4852-8530-66D5CD830068}" presName="bgRect" presStyleLbl="bgShp" presStyleIdx="0" presStyleCnt="4"/>
      <dgm:spPr/>
    </dgm:pt>
    <dgm:pt modelId="{EFC9FB63-56CD-4C5D-87DF-721F2D19939E}" type="pres">
      <dgm:prSet presAssocID="{F96C327F-5DCC-4852-8530-66D5CD830068}" presName="iconRect" presStyleLbl="node1" presStyleIdx="0" presStyleCnt="4"/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a:blipFill>
      </dgm:spPr>
      <dgm:extLst>
        <a:ext uri="{E40237B7-FDA0-4F09-8148-C483321AD2D9}">
          <dgm14:cNvPr xmlns:dgm14="http://schemas.microsoft.com/office/drawing/2010/diagram" id="0" name="" descr="Confused Person"/>
        </a:ext>
      </dgm:extLst>
    </dgm:pt>
    <dgm:pt modelId="{4D1EB2E9-8523-4F3A-8AAA-5C9A6486088F}" type="pres">
      <dgm:prSet presAssocID="{F96C327F-5DCC-4852-8530-66D5CD830068}" presName="spaceRect" presStyleCnt="0"/>
      <dgm:spPr/>
    </dgm:pt>
    <dgm:pt modelId="{EF27D859-4BF2-4E23-88FA-D2DABA31F569}" type="pres">
      <dgm:prSet presAssocID="{F96C327F-5DCC-4852-8530-66D5CD830068}" presName="parTx" presStyleLbl="revTx" presStyleIdx="0" presStyleCnt="4">
        <dgm:presLayoutVars>
          <dgm:chMax val="0"/>
          <dgm:chPref val="0"/>
        </dgm:presLayoutVars>
      </dgm:prSet>
      <dgm:spPr/>
    </dgm:pt>
    <dgm:pt modelId="{C678A583-B651-4340-AEE5-0891A7D957B7}" type="pres">
      <dgm:prSet presAssocID="{4A8C7ADC-6E5C-4419-834C-BFDE9422A449}" presName="sibTrans" presStyleCnt="0"/>
      <dgm:spPr/>
    </dgm:pt>
    <dgm:pt modelId="{1AD9AF1F-DF87-4D95-AF9A-B30082E41627}" type="pres">
      <dgm:prSet presAssocID="{3B108CB1-1F70-4884-B3B9-CB3A14559954}" presName="compNode" presStyleCnt="0"/>
      <dgm:spPr/>
    </dgm:pt>
    <dgm:pt modelId="{015609D0-C228-448D-B9D3-7C4EBE8DE8B1}" type="pres">
      <dgm:prSet presAssocID="{3B108CB1-1F70-4884-B3B9-CB3A14559954}" presName="bgRect" presStyleLbl="bgShp" presStyleIdx="1" presStyleCnt="4"/>
      <dgm:spPr/>
    </dgm:pt>
    <dgm:pt modelId="{0FBCC331-6D22-47F0-A640-09217EEE910F}" type="pres">
      <dgm:prSet presAssocID="{3B108CB1-1F70-4884-B3B9-CB3A14559954}" presName="iconRect" presStyleLbl="node1" presStyleIdx="1" presStyleCnt="4"/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a:blipFill>
      </dgm:spPr>
      <dgm:extLst>
        <a:ext uri="{E40237B7-FDA0-4F09-8148-C483321AD2D9}">
          <dgm14:cNvPr xmlns:dgm14="http://schemas.microsoft.com/office/drawing/2010/diagram" id="0" name="" descr="Envelope"/>
        </a:ext>
      </dgm:extLst>
    </dgm:pt>
    <dgm:pt modelId="{7249791D-327D-4EC4-B95E-85FBF5437B78}" type="pres">
      <dgm:prSet presAssocID="{3B108CB1-1F70-4884-B3B9-CB3A14559954}" presName="spaceRect" presStyleCnt="0"/>
      <dgm:spPr/>
    </dgm:pt>
    <dgm:pt modelId="{A809BB8A-BBE7-4C06-BF0F-C7CFD8E3454F}" type="pres">
      <dgm:prSet presAssocID="{3B108CB1-1F70-4884-B3B9-CB3A14559954}" presName="parTx" presStyleLbl="revTx" presStyleIdx="1" presStyleCnt="4">
        <dgm:presLayoutVars>
          <dgm:chMax val="0"/>
          <dgm:chPref val="0"/>
        </dgm:presLayoutVars>
      </dgm:prSet>
      <dgm:spPr/>
    </dgm:pt>
    <dgm:pt modelId="{BABD3ABE-B676-4BCF-A1C9-0FCB15450097}" type="pres">
      <dgm:prSet presAssocID="{73A79510-5290-44B7-8AD4-8DC4F44C9FC4}" presName="sibTrans" presStyleCnt="0"/>
      <dgm:spPr/>
    </dgm:pt>
    <dgm:pt modelId="{3E81D2AB-396F-4A6E-9889-AE4B97620F44}" type="pres">
      <dgm:prSet presAssocID="{A5E2CC43-816C-4A86-B938-23ED4C4DC658}" presName="compNode" presStyleCnt="0"/>
      <dgm:spPr/>
    </dgm:pt>
    <dgm:pt modelId="{E4258A3B-49A5-4632-A876-BD395C254E84}" type="pres">
      <dgm:prSet presAssocID="{A5E2CC43-816C-4A86-B938-23ED4C4DC658}" presName="bgRect" presStyleLbl="bgShp" presStyleIdx="2" presStyleCnt="4"/>
      <dgm:spPr/>
    </dgm:pt>
    <dgm:pt modelId="{AE7E649C-37A5-4DE1-B779-C199D3925D37}" type="pres">
      <dgm:prSet presAssocID="{A5E2CC43-816C-4A86-B938-23ED4C4DC658}" presName="iconRect" presStyleLbl="node1" presStyleIdx="2" presStyleCnt="4"/>
      <dgm:spPr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a:blipFill>
      </dgm:spPr>
      <dgm:extLst>
        <a:ext uri="{E40237B7-FDA0-4F09-8148-C483321AD2D9}">
          <dgm14:cNvPr xmlns:dgm14="http://schemas.microsoft.com/office/drawing/2010/diagram" id="0" name="" descr="Warning"/>
        </a:ext>
      </dgm:extLst>
    </dgm:pt>
    <dgm:pt modelId="{80ED1C52-A9AC-46AB-B548-750194AC06F8}" type="pres">
      <dgm:prSet presAssocID="{A5E2CC43-816C-4A86-B938-23ED4C4DC658}" presName="spaceRect" presStyleCnt="0"/>
      <dgm:spPr/>
    </dgm:pt>
    <dgm:pt modelId="{8B338477-D037-4486-88D8-42F29B24230E}" type="pres">
      <dgm:prSet presAssocID="{A5E2CC43-816C-4A86-B938-23ED4C4DC658}" presName="parTx" presStyleLbl="revTx" presStyleIdx="2" presStyleCnt="4">
        <dgm:presLayoutVars>
          <dgm:chMax val="0"/>
          <dgm:chPref val="0"/>
        </dgm:presLayoutVars>
      </dgm:prSet>
      <dgm:spPr/>
    </dgm:pt>
    <dgm:pt modelId="{E8D61A13-E037-4447-BB49-88B6E3244472}" type="pres">
      <dgm:prSet presAssocID="{B6F0320D-6CE1-4C1E-9497-BCFDF8C649A0}" presName="sibTrans" presStyleCnt="0"/>
      <dgm:spPr/>
    </dgm:pt>
    <dgm:pt modelId="{D3B26A25-026D-4729-B6CE-5EB6040933C9}" type="pres">
      <dgm:prSet presAssocID="{A79E01CC-5586-4E82-B37B-BF75DB08ECEF}" presName="compNode" presStyleCnt="0"/>
      <dgm:spPr/>
    </dgm:pt>
    <dgm:pt modelId="{272A4618-5156-4AD2-830F-51979F049B96}" type="pres">
      <dgm:prSet presAssocID="{A79E01CC-5586-4E82-B37B-BF75DB08ECEF}" presName="bgRect" presStyleLbl="bgShp" presStyleIdx="3" presStyleCnt="4" custLinFactNeighborY="19653"/>
      <dgm:spPr/>
    </dgm:pt>
    <dgm:pt modelId="{83639282-8798-476B-AA77-1A3116296AAE}" type="pres">
      <dgm:prSet presAssocID="{A79E01CC-5586-4E82-B37B-BF75DB08ECEF}" presName="iconRect" presStyleLbl="node1" presStyleIdx="3" presStyleCnt="4"/>
      <dgm:spPr>
        <a:blipFill>
          <a:blip xmlns:r="http://schemas.openxmlformats.org/officeDocument/2006/relationships"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a:blipFill>
      </dgm:spPr>
      <dgm:extLst>
        <a:ext uri="{E40237B7-FDA0-4F09-8148-C483321AD2D9}">
          <dgm14:cNvPr xmlns:dgm14="http://schemas.microsoft.com/office/drawing/2010/diagram" id="0" name="" descr="Medal"/>
        </a:ext>
      </dgm:extLst>
    </dgm:pt>
    <dgm:pt modelId="{F801A8DC-6C48-4A7D-84BA-8F0DC2E844BF}" type="pres">
      <dgm:prSet presAssocID="{A79E01CC-5586-4E82-B37B-BF75DB08ECEF}" presName="spaceRect" presStyleCnt="0"/>
      <dgm:spPr/>
    </dgm:pt>
    <dgm:pt modelId="{327B5D54-C83C-4F97-87E1-B222958CFDA3}" type="pres">
      <dgm:prSet presAssocID="{A79E01CC-5586-4E82-B37B-BF75DB08ECEF}" presName="parTx" presStyleLbl="revTx" presStyleIdx="3" presStyleCnt="4">
        <dgm:presLayoutVars>
          <dgm:chMax val="0"/>
          <dgm:chPref val="0"/>
        </dgm:presLayoutVars>
      </dgm:prSet>
      <dgm:spPr/>
    </dgm:pt>
  </dgm:ptLst>
  <dgm:cxnLst>
    <dgm:cxn modelId="{38B0A304-CFA5-4E55-9CC9-C5CFC28485F2}" srcId="{EC873A8B-4FC7-4A4D-9CE2-6E013DCD4259}" destId="{A5E2CC43-816C-4A86-B938-23ED4C4DC658}" srcOrd="2" destOrd="0" parTransId="{B51B5FD9-CECD-45D6-A8C9-E0730D2E69B2}" sibTransId="{B6F0320D-6CE1-4C1E-9497-BCFDF8C649A0}"/>
    <dgm:cxn modelId="{AE96FA1A-9E3C-4A92-BF06-E422A7946562}" srcId="{EC873A8B-4FC7-4A4D-9CE2-6E013DCD4259}" destId="{F96C327F-5DCC-4852-8530-66D5CD830068}" srcOrd="0" destOrd="0" parTransId="{C539C78D-F238-45CF-A693-B539A0DBA9C3}" sibTransId="{4A8C7ADC-6E5C-4419-834C-BFDE9422A449}"/>
    <dgm:cxn modelId="{EF2AFB54-4CE8-4850-9AB4-5BF282662A34}" type="presOf" srcId="{EC873A8B-4FC7-4A4D-9CE2-6E013DCD4259}" destId="{E3C55A0E-10C9-4031-A4DE-0BC83EBE64D0}" srcOrd="0" destOrd="0" presId="urn:microsoft.com/office/officeart/2018/2/layout/IconVerticalSolidList"/>
    <dgm:cxn modelId="{83B23E59-C4FA-4F05-AC91-C1C128A31123}" type="presOf" srcId="{3B108CB1-1F70-4884-B3B9-CB3A14559954}" destId="{A809BB8A-BBE7-4C06-BF0F-C7CFD8E3454F}" srcOrd="0" destOrd="0" presId="urn:microsoft.com/office/officeart/2018/2/layout/IconVerticalSolidList"/>
    <dgm:cxn modelId="{5C14BB80-B21B-46FD-95C3-85B70E72CA66}" srcId="{EC873A8B-4FC7-4A4D-9CE2-6E013DCD4259}" destId="{A79E01CC-5586-4E82-B37B-BF75DB08ECEF}" srcOrd="3" destOrd="0" parTransId="{D7FF57DC-3C67-4796-A6E2-01BE9F6B5D22}" sibTransId="{BC3E522D-9BB0-4FE6-A9D5-4FD9049BF023}"/>
    <dgm:cxn modelId="{2B54C295-4B1A-49E6-BE9E-71BB4B351090}" type="presOf" srcId="{F96C327F-5DCC-4852-8530-66D5CD830068}" destId="{EF27D859-4BF2-4E23-88FA-D2DABA31F569}" srcOrd="0" destOrd="0" presId="urn:microsoft.com/office/officeart/2018/2/layout/IconVerticalSolidList"/>
    <dgm:cxn modelId="{3848ABBD-6C1C-4660-9ED0-36B6ADE09DA1}" type="presOf" srcId="{A5E2CC43-816C-4A86-B938-23ED4C4DC658}" destId="{8B338477-D037-4486-88D8-42F29B24230E}" srcOrd="0" destOrd="0" presId="urn:microsoft.com/office/officeart/2018/2/layout/IconVerticalSolidList"/>
    <dgm:cxn modelId="{8914DFDE-B3BF-4E84-A573-F068E1438AD1}" type="presOf" srcId="{A79E01CC-5586-4E82-B37B-BF75DB08ECEF}" destId="{327B5D54-C83C-4F97-87E1-B222958CFDA3}" srcOrd="0" destOrd="0" presId="urn:microsoft.com/office/officeart/2018/2/layout/IconVerticalSolidList"/>
    <dgm:cxn modelId="{40C0DCE1-BE08-44C1-88DD-7326C96E2BE5}" srcId="{EC873A8B-4FC7-4A4D-9CE2-6E013DCD4259}" destId="{3B108CB1-1F70-4884-B3B9-CB3A14559954}" srcOrd="1" destOrd="0" parTransId="{45BEC6F0-37FE-4797-A05D-6E1170BF0647}" sibTransId="{73A79510-5290-44B7-8AD4-8DC4F44C9FC4}"/>
    <dgm:cxn modelId="{392446CD-FDD5-4675-B1D8-0474749CE654}" type="presParOf" srcId="{E3C55A0E-10C9-4031-A4DE-0BC83EBE64D0}" destId="{85246EB4-2673-48A3-8677-4C1D9B90BC17}" srcOrd="0" destOrd="0" presId="urn:microsoft.com/office/officeart/2018/2/layout/IconVerticalSolidList"/>
    <dgm:cxn modelId="{E07DCBF0-A549-40D6-8FD7-480D71B5C13D}" type="presParOf" srcId="{85246EB4-2673-48A3-8677-4C1D9B90BC17}" destId="{A27E8B20-6014-42AB-9E91-B6A44F4A0D04}" srcOrd="0" destOrd="0" presId="urn:microsoft.com/office/officeart/2018/2/layout/IconVerticalSolidList"/>
    <dgm:cxn modelId="{902A4BC3-A36E-46A7-A623-219FBE322CA1}" type="presParOf" srcId="{85246EB4-2673-48A3-8677-4C1D9B90BC17}" destId="{EFC9FB63-56CD-4C5D-87DF-721F2D19939E}" srcOrd="1" destOrd="0" presId="urn:microsoft.com/office/officeart/2018/2/layout/IconVerticalSolidList"/>
    <dgm:cxn modelId="{B1102E9D-7B6D-4386-9200-15F217EBADE2}" type="presParOf" srcId="{85246EB4-2673-48A3-8677-4C1D9B90BC17}" destId="{4D1EB2E9-8523-4F3A-8AAA-5C9A6486088F}" srcOrd="2" destOrd="0" presId="urn:microsoft.com/office/officeart/2018/2/layout/IconVerticalSolidList"/>
    <dgm:cxn modelId="{ED426478-7CD8-4D15-88F7-6483F4FEE851}" type="presParOf" srcId="{85246EB4-2673-48A3-8677-4C1D9B90BC17}" destId="{EF27D859-4BF2-4E23-88FA-D2DABA31F569}" srcOrd="3" destOrd="0" presId="urn:microsoft.com/office/officeart/2018/2/layout/IconVerticalSolidList"/>
    <dgm:cxn modelId="{D8A57D48-8E51-4C6D-9213-F6C96AD4EE8F}" type="presParOf" srcId="{E3C55A0E-10C9-4031-A4DE-0BC83EBE64D0}" destId="{C678A583-B651-4340-AEE5-0891A7D957B7}" srcOrd="1" destOrd="0" presId="urn:microsoft.com/office/officeart/2018/2/layout/IconVerticalSolidList"/>
    <dgm:cxn modelId="{2321B8D2-7C35-433A-8E61-42426C4B66E7}" type="presParOf" srcId="{E3C55A0E-10C9-4031-A4DE-0BC83EBE64D0}" destId="{1AD9AF1F-DF87-4D95-AF9A-B30082E41627}" srcOrd="2" destOrd="0" presId="urn:microsoft.com/office/officeart/2018/2/layout/IconVerticalSolidList"/>
    <dgm:cxn modelId="{53F89E03-8847-4772-A1D7-D24A0CCDE479}" type="presParOf" srcId="{1AD9AF1F-DF87-4D95-AF9A-B30082E41627}" destId="{015609D0-C228-448D-B9D3-7C4EBE8DE8B1}" srcOrd="0" destOrd="0" presId="urn:microsoft.com/office/officeart/2018/2/layout/IconVerticalSolidList"/>
    <dgm:cxn modelId="{2B2FA1DD-73C0-4733-B93F-3BFED8C5B0F6}" type="presParOf" srcId="{1AD9AF1F-DF87-4D95-AF9A-B30082E41627}" destId="{0FBCC331-6D22-47F0-A640-09217EEE910F}" srcOrd="1" destOrd="0" presId="urn:microsoft.com/office/officeart/2018/2/layout/IconVerticalSolidList"/>
    <dgm:cxn modelId="{2414789B-1210-42B4-9BB6-22404CABC970}" type="presParOf" srcId="{1AD9AF1F-DF87-4D95-AF9A-B30082E41627}" destId="{7249791D-327D-4EC4-B95E-85FBF5437B78}" srcOrd="2" destOrd="0" presId="urn:microsoft.com/office/officeart/2018/2/layout/IconVerticalSolidList"/>
    <dgm:cxn modelId="{4EE21E36-3BB1-436C-A06B-777AEFDE56F6}" type="presParOf" srcId="{1AD9AF1F-DF87-4D95-AF9A-B30082E41627}" destId="{A809BB8A-BBE7-4C06-BF0F-C7CFD8E3454F}" srcOrd="3" destOrd="0" presId="urn:microsoft.com/office/officeart/2018/2/layout/IconVerticalSolidList"/>
    <dgm:cxn modelId="{B5E7B3E2-E7A4-4577-B5E1-990E6D59C28A}" type="presParOf" srcId="{E3C55A0E-10C9-4031-A4DE-0BC83EBE64D0}" destId="{BABD3ABE-B676-4BCF-A1C9-0FCB15450097}" srcOrd="3" destOrd="0" presId="urn:microsoft.com/office/officeart/2018/2/layout/IconVerticalSolidList"/>
    <dgm:cxn modelId="{F1B10B3A-0D5E-46DD-BFBC-DA9759A36E55}" type="presParOf" srcId="{E3C55A0E-10C9-4031-A4DE-0BC83EBE64D0}" destId="{3E81D2AB-396F-4A6E-9889-AE4B97620F44}" srcOrd="4" destOrd="0" presId="urn:microsoft.com/office/officeart/2018/2/layout/IconVerticalSolidList"/>
    <dgm:cxn modelId="{75C0105A-92D7-4D88-8DC7-024F3769D603}" type="presParOf" srcId="{3E81D2AB-396F-4A6E-9889-AE4B97620F44}" destId="{E4258A3B-49A5-4632-A876-BD395C254E84}" srcOrd="0" destOrd="0" presId="urn:microsoft.com/office/officeart/2018/2/layout/IconVerticalSolidList"/>
    <dgm:cxn modelId="{F958C2FE-903A-478A-99F9-22D0BEF2AD2A}" type="presParOf" srcId="{3E81D2AB-396F-4A6E-9889-AE4B97620F44}" destId="{AE7E649C-37A5-4DE1-B779-C199D3925D37}" srcOrd="1" destOrd="0" presId="urn:microsoft.com/office/officeart/2018/2/layout/IconVerticalSolidList"/>
    <dgm:cxn modelId="{510A712B-C7BF-4604-82EC-9FE51F4DA0DB}" type="presParOf" srcId="{3E81D2AB-396F-4A6E-9889-AE4B97620F44}" destId="{80ED1C52-A9AC-46AB-B548-750194AC06F8}" srcOrd="2" destOrd="0" presId="urn:microsoft.com/office/officeart/2018/2/layout/IconVerticalSolidList"/>
    <dgm:cxn modelId="{D1515308-A0B8-4BA4-8686-D583A86BBE39}" type="presParOf" srcId="{3E81D2AB-396F-4A6E-9889-AE4B97620F44}" destId="{8B338477-D037-4486-88D8-42F29B24230E}" srcOrd="3" destOrd="0" presId="urn:microsoft.com/office/officeart/2018/2/layout/IconVerticalSolidList"/>
    <dgm:cxn modelId="{BFD11CDB-1339-436A-85D8-7385BD2B5D29}" type="presParOf" srcId="{E3C55A0E-10C9-4031-A4DE-0BC83EBE64D0}" destId="{E8D61A13-E037-4447-BB49-88B6E3244472}" srcOrd="5" destOrd="0" presId="urn:microsoft.com/office/officeart/2018/2/layout/IconVerticalSolidList"/>
    <dgm:cxn modelId="{B25D70AD-550C-4156-88EF-EB4E2E81AAD8}" type="presParOf" srcId="{E3C55A0E-10C9-4031-A4DE-0BC83EBE64D0}" destId="{D3B26A25-026D-4729-B6CE-5EB6040933C9}" srcOrd="6" destOrd="0" presId="urn:microsoft.com/office/officeart/2018/2/layout/IconVerticalSolidList"/>
    <dgm:cxn modelId="{D130E76D-A357-4BBF-87A2-40ED28E9EDDC}" type="presParOf" srcId="{D3B26A25-026D-4729-B6CE-5EB6040933C9}" destId="{272A4618-5156-4AD2-830F-51979F049B96}" srcOrd="0" destOrd="0" presId="urn:microsoft.com/office/officeart/2018/2/layout/IconVerticalSolidList"/>
    <dgm:cxn modelId="{C189EA23-D130-4C57-A8F9-26CDB14F41AE}" type="presParOf" srcId="{D3B26A25-026D-4729-B6CE-5EB6040933C9}" destId="{83639282-8798-476B-AA77-1A3116296AAE}" srcOrd="1" destOrd="0" presId="urn:microsoft.com/office/officeart/2018/2/layout/IconVerticalSolidList"/>
    <dgm:cxn modelId="{E768644E-86B1-4C9C-BC05-D73FF7466FF0}" type="presParOf" srcId="{D3B26A25-026D-4729-B6CE-5EB6040933C9}" destId="{F801A8DC-6C48-4A7D-84BA-8F0DC2E844BF}" srcOrd="2" destOrd="0" presId="urn:microsoft.com/office/officeart/2018/2/layout/IconVerticalSolidList"/>
    <dgm:cxn modelId="{CDD38387-9C17-414F-8130-C32708F63F11}" type="presParOf" srcId="{D3B26A25-026D-4729-B6CE-5EB6040933C9}" destId="{327B5D54-C83C-4F97-87E1-B222958CFDA3}" srcOrd="3" destOrd="0" presId="urn:microsoft.com/office/officeart/2018/2/layout/IconVerticalSolidList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93C902FB-D9A1-4CA9-83BC-4D0847D44E19}" type="doc">
      <dgm:prSet loTypeId="urn:microsoft.com/office/officeart/2018/2/layout/IconVerticalSolidList" loCatId="icon" qsTypeId="urn:microsoft.com/office/officeart/2005/8/quickstyle/simple1" qsCatId="simple" csTypeId="urn:microsoft.com/office/officeart/2018/5/colors/Iconchunking_neutralicontext_colorful1" csCatId="colorful" phldr="1"/>
      <dgm:spPr/>
      <dgm:t>
        <a:bodyPr/>
        <a:lstStyle/>
        <a:p>
          <a:endParaRPr lang="en-US"/>
        </a:p>
      </dgm:t>
    </dgm:pt>
    <dgm:pt modelId="{F0967A21-8ACA-4C4A-9D6B-B87EE5FC8EAC}">
      <dgm:prSet/>
      <dgm:spPr/>
      <dgm:t>
        <a:bodyPr/>
        <a:lstStyle/>
        <a:p>
          <a:r>
            <a:rPr lang="en-US"/>
            <a:t>Your trip will be burdened with time delays if you perform poorly on tasks. Do tasks accurately the first time to avoid these. </a:t>
          </a:r>
        </a:p>
      </dgm:t>
    </dgm:pt>
    <dgm:pt modelId="{AE215F58-35BB-4C93-B158-0B59FCDC430A}" type="parTrans" cxnId="{5AE2E3D9-66AC-43F0-85ED-661B39DC4442}">
      <dgm:prSet/>
      <dgm:spPr/>
      <dgm:t>
        <a:bodyPr/>
        <a:lstStyle/>
        <a:p>
          <a:endParaRPr lang="en-US"/>
        </a:p>
      </dgm:t>
    </dgm:pt>
    <dgm:pt modelId="{04A488E1-0519-4515-A1B6-D4EC6D544695}" type="sibTrans" cxnId="{5AE2E3D9-66AC-43F0-85ED-661B39DC4442}">
      <dgm:prSet/>
      <dgm:spPr/>
      <dgm:t>
        <a:bodyPr/>
        <a:lstStyle/>
        <a:p>
          <a:endParaRPr lang="en-US"/>
        </a:p>
      </dgm:t>
    </dgm:pt>
    <dgm:pt modelId="{0F8BFAF7-1E42-42B8-B279-0C93925DE2CC}">
      <dgm:prSet/>
      <dgm:spPr/>
      <dgm:t>
        <a:bodyPr/>
        <a:lstStyle/>
        <a:p>
          <a:r>
            <a:rPr lang="en-US"/>
            <a:t>Work together! Your shared expertise will carry you further and faster. </a:t>
          </a:r>
        </a:p>
      </dgm:t>
    </dgm:pt>
    <dgm:pt modelId="{DC836190-10A7-422A-A4B4-BCBBD3772710}" type="parTrans" cxnId="{DE194143-D56C-43F1-A35A-BB45123A53EE}">
      <dgm:prSet/>
      <dgm:spPr/>
      <dgm:t>
        <a:bodyPr/>
        <a:lstStyle/>
        <a:p>
          <a:endParaRPr lang="en-US"/>
        </a:p>
      </dgm:t>
    </dgm:pt>
    <dgm:pt modelId="{B752062A-7555-4783-95FE-BFB2CCB41885}" type="sibTrans" cxnId="{DE194143-D56C-43F1-A35A-BB45123A53EE}">
      <dgm:prSet/>
      <dgm:spPr/>
      <dgm:t>
        <a:bodyPr/>
        <a:lstStyle/>
        <a:p>
          <a:endParaRPr lang="en-US"/>
        </a:p>
      </dgm:t>
    </dgm:pt>
    <dgm:pt modelId="{02C1CB03-3B21-4D1D-B4C5-019A9DF91E32}">
      <dgm:prSet/>
      <dgm:spPr/>
      <dgm:t>
        <a:bodyPr/>
        <a:lstStyle/>
        <a:p>
          <a:r>
            <a:rPr lang="en-US"/>
            <a:t>You cannot look up answers electronically unless instructed to do so. Rule breakers receive time delays!</a:t>
          </a:r>
        </a:p>
      </dgm:t>
    </dgm:pt>
    <dgm:pt modelId="{F97F214A-8120-4BE8-85A7-EDF140CD343B}" type="parTrans" cxnId="{502953DD-E1FA-43D4-A4A0-B9480DF82AC7}">
      <dgm:prSet/>
      <dgm:spPr/>
      <dgm:t>
        <a:bodyPr/>
        <a:lstStyle/>
        <a:p>
          <a:endParaRPr lang="en-US"/>
        </a:p>
      </dgm:t>
    </dgm:pt>
    <dgm:pt modelId="{F888B77C-4CDB-496F-8607-876F43DE22D8}" type="sibTrans" cxnId="{502953DD-E1FA-43D4-A4A0-B9480DF82AC7}">
      <dgm:prSet/>
      <dgm:spPr/>
      <dgm:t>
        <a:bodyPr/>
        <a:lstStyle/>
        <a:p>
          <a:endParaRPr lang="en-US"/>
        </a:p>
      </dgm:t>
    </dgm:pt>
    <dgm:pt modelId="{F3BB42D9-E55F-4CBA-ADA8-1FDB6A775B51}" type="pres">
      <dgm:prSet presAssocID="{93C902FB-D9A1-4CA9-83BC-4D0847D44E19}" presName="root" presStyleCnt="0">
        <dgm:presLayoutVars>
          <dgm:dir/>
          <dgm:resizeHandles val="exact"/>
        </dgm:presLayoutVars>
      </dgm:prSet>
      <dgm:spPr/>
    </dgm:pt>
    <dgm:pt modelId="{B393F910-CBF9-4F07-93FC-EB3EC1C6291C}" type="pres">
      <dgm:prSet presAssocID="{F0967A21-8ACA-4C4A-9D6B-B87EE5FC8EAC}" presName="compNode" presStyleCnt="0"/>
      <dgm:spPr/>
    </dgm:pt>
    <dgm:pt modelId="{74FAACA5-8267-445A-92A1-A1CC49F53C3F}" type="pres">
      <dgm:prSet presAssocID="{F0967A21-8ACA-4C4A-9D6B-B87EE5FC8EAC}" presName="bgRect" presStyleLbl="bgShp" presStyleIdx="0" presStyleCnt="3"/>
      <dgm:spPr/>
    </dgm:pt>
    <dgm:pt modelId="{550A4141-48BC-409E-9B99-931E91A9F6DA}" type="pres">
      <dgm:prSet presAssocID="{F0967A21-8ACA-4C4A-9D6B-B87EE5FC8EAC}" presName="iconRect" presStyleLbl="node1" presStyleIdx="0" presStyleCnt="3"/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a:blipFill>
        <a:ln>
          <a:noFill/>
        </a:ln>
      </dgm:spPr>
      <dgm:extLst>
        <a:ext uri="{E40237B7-FDA0-4F09-8148-C483321AD2D9}">
          <dgm14:cNvPr xmlns:dgm14="http://schemas.microsoft.com/office/drawing/2010/diagram" id="0" name="" descr="Clock"/>
        </a:ext>
      </dgm:extLst>
    </dgm:pt>
    <dgm:pt modelId="{96728898-B52A-4B02-A5E9-7E463A28AD39}" type="pres">
      <dgm:prSet presAssocID="{F0967A21-8ACA-4C4A-9D6B-B87EE5FC8EAC}" presName="spaceRect" presStyleCnt="0"/>
      <dgm:spPr/>
    </dgm:pt>
    <dgm:pt modelId="{D32901E1-353F-4A35-974D-F43924C9D9C2}" type="pres">
      <dgm:prSet presAssocID="{F0967A21-8ACA-4C4A-9D6B-B87EE5FC8EAC}" presName="parTx" presStyleLbl="revTx" presStyleIdx="0" presStyleCnt="3">
        <dgm:presLayoutVars>
          <dgm:chMax val="0"/>
          <dgm:chPref val="0"/>
        </dgm:presLayoutVars>
      </dgm:prSet>
      <dgm:spPr/>
    </dgm:pt>
    <dgm:pt modelId="{55261BB2-C76B-46E4-BA0F-BE786CEF1565}" type="pres">
      <dgm:prSet presAssocID="{04A488E1-0519-4515-A1B6-D4EC6D544695}" presName="sibTrans" presStyleCnt="0"/>
      <dgm:spPr/>
    </dgm:pt>
    <dgm:pt modelId="{41BE792A-76E3-49D8-B978-047D1900DD1C}" type="pres">
      <dgm:prSet presAssocID="{0F8BFAF7-1E42-42B8-B279-0C93925DE2CC}" presName="compNode" presStyleCnt="0"/>
      <dgm:spPr/>
    </dgm:pt>
    <dgm:pt modelId="{B7D69664-53FD-488D-82E6-9E9B1196AB05}" type="pres">
      <dgm:prSet presAssocID="{0F8BFAF7-1E42-42B8-B279-0C93925DE2CC}" presName="bgRect" presStyleLbl="bgShp" presStyleIdx="1" presStyleCnt="3"/>
      <dgm:spPr/>
    </dgm:pt>
    <dgm:pt modelId="{22510EE0-CE93-458A-B76B-100B2ABB678E}" type="pres">
      <dgm:prSet presAssocID="{0F8BFAF7-1E42-42B8-B279-0C93925DE2CC}" presName="iconRect" presStyleLbl="node1" presStyleIdx="1" presStyleCnt="3"/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a:blipFill>
        <a:ln>
          <a:noFill/>
        </a:ln>
      </dgm:spPr>
      <dgm:extLst>
        <a:ext uri="{E40237B7-FDA0-4F09-8148-C483321AD2D9}">
          <dgm14:cNvPr xmlns:dgm14="http://schemas.microsoft.com/office/drawing/2010/diagram" id="0" name="" descr="Share With Person"/>
        </a:ext>
      </dgm:extLst>
    </dgm:pt>
    <dgm:pt modelId="{D55C392A-E402-419F-A102-3236C910772A}" type="pres">
      <dgm:prSet presAssocID="{0F8BFAF7-1E42-42B8-B279-0C93925DE2CC}" presName="spaceRect" presStyleCnt="0"/>
      <dgm:spPr/>
    </dgm:pt>
    <dgm:pt modelId="{19AE23B1-1AC4-43F1-A5E3-50FC03D692F5}" type="pres">
      <dgm:prSet presAssocID="{0F8BFAF7-1E42-42B8-B279-0C93925DE2CC}" presName="parTx" presStyleLbl="revTx" presStyleIdx="1" presStyleCnt="3">
        <dgm:presLayoutVars>
          <dgm:chMax val="0"/>
          <dgm:chPref val="0"/>
        </dgm:presLayoutVars>
      </dgm:prSet>
      <dgm:spPr/>
    </dgm:pt>
    <dgm:pt modelId="{DC2E6580-EFC0-44FA-B025-38EAAEFD880D}" type="pres">
      <dgm:prSet presAssocID="{B752062A-7555-4783-95FE-BFB2CCB41885}" presName="sibTrans" presStyleCnt="0"/>
      <dgm:spPr/>
    </dgm:pt>
    <dgm:pt modelId="{1BC0DB83-3D08-47F2-869C-76D84A7073BE}" type="pres">
      <dgm:prSet presAssocID="{02C1CB03-3B21-4D1D-B4C5-019A9DF91E32}" presName="compNode" presStyleCnt="0"/>
      <dgm:spPr/>
    </dgm:pt>
    <dgm:pt modelId="{0DF97F09-E805-4D59-8EE4-D17123A48771}" type="pres">
      <dgm:prSet presAssocID="{02C1CB03-3B21-4D1D-B4C5-019A9DF91E32}" presName="bgRect" presStyleLbl="bgShp" presStyleIdx="2" presStyleCnt="3"/>
      <dgm:spPr/>
    </dgm:pt>
    <dgm:pt modelId="{9BE9FBA7-0412-473D-86D4-FEEA49CE56EA}" type="pres">
      <dgm:prSet presAssocID="{02C1CB03-3B21-4D1D-B4C5-019A9DF91E32}" presName="iconRect" presStyleLbl="node1" presStyleIdx="2" presStyleCnt="3"/>
      <dgm:spPr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a:blipFill>
        <a:ln>
          <a:noFill/>
        </a:ln>
      </dgm:spPr>
      <dgm:extLst>
        <a:ext uri="{E40237B7-FDA0-4F09-8148-C483321AD2D9}">
          <dgm14:cNvPr xmlns:dgm14="http://schemas.microsoft.com/office/drawing/2010/diagram" id="0" name="" descr="Speed Bump"/>
        </a:ext>
      </dgm:extLst>
    </dgm:pt>
    <dgm:pt modelId="{D87BF671-E5AC-49E2-B6AD-6A5646A34759}" type="pres">
      <dgm:prSet presAssocID="{02C1CB03-3B21-4D1D-B4C5-019A9DF91E32}" presName="spaceRect" presStyleCnt="0"/>
      <dgm:spPr/>
    </dgm:pt>
    <dgm:pt modelId="{62947D69-2CCC-44D6-ABFE-E016CC4509A6}" type="pres">
      <dgm:prSet presAssocID="{02C1CB03-3B21-4D1D-B4C5-019A9DF91E32}" presName="parTx" presStyleLbl="revTx" presStyleIdx="2" presStyleCnt="3">
        <dgm:presLayoutVars>
          <dgm:chMax val="0"/>
          <dgm:chPref val="0"/>
        </dgm:presLayoutVars>
      </dgm:prSet>
      <dgm:spPr/>
    </dgm:pt>
  </dgm:ptLst>
  <dgm:cxnLst>
    <dgm:cxn modelId="{DE194143-D56C-43F1-A35A-BB45123A53EE}" srcId="{93C902FB-D9A1-4CA9-83BC-4D0847D44E19}" destId="{0F8BFAF7-1E42-42B8-B279-0C93925DE2CC}" srcOrd="1" destOrd="0" parTransId="{DC836190-10A7-422A-A4B4-BCBBD3772710}" sibTransId="{B752062A-7555-4783-95FE-BFB2CCB41885}"/>
    <dgm:cxn modelId="{70471567-B8ED-4F7D-9447-4FDFA841AC56}" type="presOf" srcId="{02C1CB03-3B21-4D1D-B4C5-019A9DF91E32}" destId="{62947D69-2CCC-44D6-ABFE-E016CC4509A6}" srcOrd="0" destOrd="0" presId="urn:microsoft.com/office/officeart/2018/2/layout/IconVerticalSolidList"/>
    <dgm:cxn modelId="{2262DFA6-F371-41F7-9B6F-FADE70209584}" type="presOf" srcId="{F0967A21-8ACA-4C4A-9D6B-B87EE5FC8EAC}" destId="{D32901E1-353F-4A35-974D-F43924C9D9C2}" srcOrd="0" destOrd="0" presId="urn:microsoft.com/office/officeart/2018/2/layout/IconVerticalSolidList"/>
    <dgm:cxn modelId="{A775CEC6-B7A1-4530-97B4-F61887BB23D1}" type="presOf" srcId="{93C902FB-D9A1-4CA9-83BC-4D0847D44E19}" destId="{F3BB42D9-E55F-4CBA-ADA8-1FDB6A775B51}" srcOrd="0" destOrd="0" presId="urn:microsoft.com/office/officeart/2018/2/layout/IconVerticalSolidList"/>
    <dgm:cxn modelId="{129208CE-52EF-4FA8-A800-BF5965E6FB0C}" type="presOf" srcId="{0F8BFAF7-1E42-42B8-B279-0C93925DE2CC}" destId="{19AE23B1-1AC4-43F1-A5E3-50FC03D692F5}" srcOrd="0" destOrd="0" presId="urn:microsoft.com/office/officeart/2018/2/layout/IconVerticalSolidList"/>
    <dgm:cxn modelId="{5AE2E3D9-66AC-43F0-85ED-661B39DC4442}" srcId="{93C902FB-D9A1-4CA9-83BC-4D0847D44E19}" destId="{F0967A21-8ACA-4C4A-9D6B-B87EE5FC8EAC}" srcOrd="0" destOrd="0" parTransId="{AE215F58-35BB-4C93-B158-0B59FCDC430A}" sibTransId="{04A488E1-0519-4515-A1B6-D4EC6D544695}"/>
    <dgm:cxn modelId="{502953DD-E1FA-43D4-A4A0-B9480DF82AC7}" srcId="{93C902FB-D9A1-4CA9-83BC-4D0847D44E19}" destId="{02C1CB03-3B21-4D1D-B4C5-019A9DF91E32}" srcOrd="2" destOrd="0" parTransId="{F97F214A-8120-4BE8-85A7-EDF140CD343B}" sibTransId="{F888B77C-4CDB-496F-8607-876F43DE22D8}"/>
    <dgm:cxn modelId="{C0D1CD5E-0DC3-41F2-9BE0-D9F6B10F53B5}" type="presParOf" srcId="{F3BB42D9-E55F-4CBA-ADA8-1FDB6A775B51}" destId="{B393F910-CBF9-4F07-93FC-EB3EC1C6291C}" srcOrd="0" destOrd="0" presId="urn:microsoft.com/office/officeart/2018/2/layout/IconVerticalSolidList"/>
    <dgm:cxn modelId="{8FE1AE78-2134-43A5-9C27-EAFFE80D1F1C}" type="presParOf" srcId="{B393F910-CBF9-4F07-93FC-EB3EC1C6291C}" destId="{74FAACA5-8267-445A-92A1-A1CC49F53C3F}" srcOrd="0" destOrd="0" presId="urn:microsoft.com/office/officeart/2018/2/layout/IconVerticalSolidList"/>
    <dgm:cxn modelId="{9691B85C-5EE7-4B4B-976D-51296777FACB}" type="presParOf" srcId="{B393F910-CBF9-4F07-93FC-EB3EC1C6291C}" destId="{550A4141-48BC-409E-9B99-931E91A9F6DA}" srcOrd="1" destOrd="0" presId="urn:microsoft.com/office/officeart/2018/2/layout/IconVerticalSolidList"/>
    <dgm:cxn modelId="{E919DF78-FEFE-475E-BF34-DF129F5AE54E}" type="presParOf" srcId="{B393F910-CBF9-4F07-93FC-EB3EC1C6291C}" destId="{96728898-B52A-4B02-A5E9-7E463A28AD39}" srcOrd="2" destOrd="0" presId="urn:microsoft.com/office/officeart/2018/2/layout/IconVerticalSolidList"/>
    <dgm:cxn modelId="{6DE4FCBD-E5A1-426A-8D12-43641E69877E}" type="presParOf" srcId="{B393F910-CBF9-4F07-93FC-EB3EC1C6291C}" destId="{D32901E1-353F-4A35-974D-F43924C9D9C2}" srcOrd="3" destOrd="0" presId="urn:microsoft.com/office/officeart/2018/2/layout/IconVerticalSolidList"/>
    <dgm:cxn modelId="{FE34E046-FFB9-4927-B52E-FDDCD97BAD36}" type="presParOf" srcId="{F3BB42D9-E55F-4CBA-ADA8-1FDB6A775B51}" destId="{55261BB2-C76B-46E4-BA0F-BE786CEF1565}" srcOrd="1" destOrd="0" presId="urn:microsoft.com/office/officeart/2018/2/layout/IconVerticalSolidList"/>
    <dgm:cxn modelId="{4BFD49CA-73B2-44D5-A520-9346E1426266}" type="presParOf" srcId="{F3BB42D9-E55F-4CBA-ADA8-1FDB6A775B51}" destId="{41BE792A-76E3-49D8-B978-047D1900DD1C}" srcOrd="2" destOrd="0" presId="urn:microsoft.com/office/officeart/2018/2/layout/IconVerticalSolidList"/>
    <dgm:cxn modelId="{23B9C8E9-14C6-4262-9458-16E85436C7FC}" type="presParOf" srcId="{41BE792A-76E3-49D8-B978-047D1900DD1C}" destId="{B7D69664-53FD-488D-82E6-9E9B1196AB05}" srcOrd="0" destOrd="0" presId="urn:microsoft.com/office/officeart/2018/2/layout/IconVerticalSolidList"/>
    <dgm:cxn modelId="{C0F98D9E-42E7-4DBF-8D85-0757200E06A4}" type="presParOf" srcId="{41BE792A-76E3-49D8-B978-047D1900DD1C}" destId="{22510EE0-CE93-458A-B76B-100B2ABB678E}" srcOrd="1" destOrd="0" presId="urn:microsoft.com/office/officeart/2018/2/layout/IconVerticalSolidList"/>
    <dgm:cxn modelId="{1293A634-FE0C-4830-825F-6D2C30F89CAA}" type="presParOf" srcId="{41BE792A-76E3-49D8-B978-047D1900DD1C}" destId="{D55C392A-E402-419F-A102-3236C910772A}" srcOrd="2" destOrd="0" presId="urn:microsoft.com/office/officeart/2018/2/layout/IconVerticalSolidList"/>
    <dgm:cxn modelId="{609076BB-A476-48B7-8977-AD4E177BECCC}" type="presParOf" srcId="{41BE792A-76E3-49D8-B978-047D1900DD1C}" destId="{19AE23B1-1AC4-43F1-A5E3-50FC03D692F5}" srcOrd="3" destOrd="0" presId="urn:microsoft.com/office/officeart/2018/2/layout/IconVerticalSolidList"/>
    <dgm:cxn modelId="{2E8DDB5D-74AD-4333-AC1F-2D2B661A1CE9}" type="presParOf" srcId="{F3BB42D9-E55F-4CBA-ADA8-1FDB6A775B51}" destId="{DC2E6580-EFC0-44FA-B025-38EAAEFD880D}" srcOrd="3" destOrd="0" presId="urn:microsoft.com/office/officeart/2018/2/layout/IconVerticalSolidList"/>
    <dgm:cxn modelId="{5DC55FEF-BAF6-4BED-A393-8D4FCDC24D02}" type="presParOf" srcId="{F3BB42D9-E55F-4CBA-ADA8-1FDB6A775B51}" destId="{1BC0DB83-3D08-47F2-869C-76D84A7073BE}" srcOrd="4" destOrd="0" presId="urn:microsoft.com/office/officeart/2018/2/layout/IconVerticalSolidList"/>
    <dgm:cxn modelId="{53A26B9D-69FF-41EC-BBE4-8CEA5F2800AC}" type="presParOf" srcId="{1BC0DB83-3D08-47F2-869C-76D84A7073BE}" destId="{0DF97F09-E805-4D59-8EE4-D17123A48771}" srcOrd="0" destOrd="0" presId="urn:microsoft.com/office/officeart/2018/2/layout/IconVerticalSolidList"/>
    <dgm:cxn modelId="{9FE37698-B075-4BEB-9A31-68E167A194F7}" type="presParOf" srcId="{1BC0DB83-3D08-47F2-869C-76D84A7073BE}" destId="{9BE9FBA7-0412-473D-86D4-FEEA49CE56EA}" srcOrd="1" destOrd="0" presId="urn:microsoft.com/office/officeart/2018/2/layout/IconVerticalSolidList"/>
    <dgm:cxn modelId="{FCBB4697-5ED3-4A2A-8380-A971A82216C0}" type="presParOf" srcId="{1BC0DB83-3D08-47F2-869C-76D84A7073BE}" destId="{D87BF671-E5AC-49E2-B6AD-6A5646A34759}" srcOrd="2" destOrd="0" presId="urn:microsoft.com/office/officeart/2018/2/layout/IconVerticalSolidList"/>
    <dgm:cxn modelId="{1A5C1E26-E00B-4364-AC1E-3F395C8AF979}" type="presParOf" srcId="{1BC0DB83-3D08-47F2-869C-76D84A7073BE}" destId="{62947D69-2CCC-44D6-ABFE-E016CC4509A6}" srcOrd="3" destOrd="0" presId="urn:microsoft.com/office/officeart/2018/2/layout/IconVerticalSolidList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A27E8B20-6014-42AB-9E91-B6A44F4A0D04}">
      <dsp:nvSpPr>
        <dsp:cNvPr id="0" name=""/>
        <dsp:cNvSpPr/>
      </dsp:nvSpPr>
      <dsp:spPr>
        <a:xfrm>
          <a:off x="0" y="1805"/>
          <a:ext cx="10515600" cy="915310"/>
        </a:xfrm>
        <a:prstGeom prst="roundRect">
          <a:avLst>
            <a:gd name="adj" fmla="val 10000"/>
          </a:avLst>
        </a:prstGeom>
        <a:solidFill>
          <a:schemeClr val="accent1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EFC9FB63-56CD-4C5D-87DF-721F2D19939E}">
      <dsp:nvSpPr>
        <dsp:cNvPr id="0" name=""/>
        <dsp:cNvSpPr/>
      </dsp:nvSpPr>
      <dsp:spPr>
        <a:xfrm>
          <a:off x="276881" y="207750"/>
          <a:ext cx="503420" cy="503420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EF27D859-4BF2-4E23-88FA-D2DABA31F569}">
      <dsp:nvSpPr>
        <dsp:cNvPr id="0" name=""/>
        <dsp:cNvSpPr/>
      </dsp:nvSpPr>
      <dsp:spPr>
        <a:xfrm>
          <a:off x="1057183" y="1805"/>
          <a:ext cx="9458416" cy="91531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6870" tIns="96870" rIns="96870" bIns="96870" numCol="1" spcCol="1270" anchor="ctr" anchorCtr="0">
          <a:noAutofit/>
        </a:bodyPr>
        <a:lstStyle/>
        <a:p>
          <a:pPr marL="0" lvl="0" indent="0" algn="l" defTabSz="622300">
            <a:lnSpc>
              <a:spcPct val="10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/>
            <a:t>You’ll receive a “Route Info Clue” to start, directing you to one of two Detour Locations. </a:t>
          </a:r>
        </a:p>
      </dsp:txBody>
      <dsp:txXfrm>
        <a:off x="1057183" y="1805"/>
        <a:ext cx="9458416" cy="915310"/>
      </dsp:txXfrm>
    </dsp:sp>
    <dsp:sp modelId="{015609D0-C228-448D-B9D3-7C4EBE8DE8B1}">
      <dsp:nvSpPr>
        <dsp:cNvPr id="0" name=""/>
        <dsp:cNvSpPr/>
      </dsp:nvSpPr>
      <dsp:spPr>
        <a:xfrm>
          <a:off x="0" y="1145944"/>
          <a:ext cx="10515600" cy="915310"/>
        </a:xfrm>
        <a:prstGeom prst="roundRect">
          <a:avLst>
            <a:gd name="adj" fmla="val 10000"/>
          </a:avLst>
        </a:prstGeom>
        <a:solidFill>
          <a:schemeClr val="accent1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0FBCC331-6D22-47F0-A640-09217EEE910F}">
      <dsp:nvSpPr>
        <dsp:cNvPr id="0" name=""/>
        <dsp:cNvSpPr/>
      </dsp:nvSpPr>
      <dsp:spPr>
        <a:xfrm>
          <a:off x="276881" y="1351889"/>
          <a:ext cx="503420" cy="503420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809BB8A-BBE7-4C06-BF0F-C7CFD8E3454F}">
      <dsp:nvSpPr>
        <dsp:cNvPr id="0" name=""/>
        <dsp:cNvSpPr/>
      </dsp:nvSpPr>
      <dsp:spPr>
        <a:xfrm>
          <a:off x="1057183" y="1145944"/>
          <a:ext cx="9458416" cy="91531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6870" tIns="96870" rIns="96870" bIns="96870" numCol="1" spcCol="1270" anchor="ctr" anchorCtr="0">
          <a:noAutofit/>
        </a:bodyPr>
        <a:lstStyle/>
        <a:p>
          <a:pPr marL="0" lvl="0" indent="0" algn="l" defTabSz="622300">
            <a:lnSpc>
              <a:spcPct val="10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/>
            <a:t>At your Detour Location, your team will receive another envelope containing “Detour Tasks”. These are two tasks that must be completed as a group. Successful completion earns you an envelope containing another “Route Info Clue” which leads to the next leg…the Roadblock</a:t>
          </a:r>
        </a:p>
      </dsp:txBody>
      <dsp:txXfrm>
        <a:off x="1057183" y="1145944"/>
        <a:ext cx="9458416" cy="915310"/>
      </dsp:txXfrm>
    </dsp:sp>
    <dsp:sp modelId="{E4258A3B-49A5-4632-A876-BD395C254E84}">
      <dsp:nvSpPr>
        <dsp:cNvPr id="0" name=""/>
        <dsp:cNvSpPr/>
      </dsp:nvSpPr>
      <dsp:spPr>
        <a:xfrm>
          <a:off x="0" y="2290082"/>
          <a:ext cx="10515600" cy="915310"/>
        </a:xfrm>
        <a:prstGeom prst="roundRect">
          <a:avLst>
            <a:gd name="adj" fmla="val 10000"/>
          </a:avLst>
        </a:prstGeom>
        <a:solidFill>
          <a:schemeClr val="accent1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AE7E649C-37A5-4DE1-B779-C199D3925D37}">
      <dsp:nvSpPr>
        <dsp:cNvPr id="0" name=""/>
        <dsp:cNvSpPr/>
      </dsp:nvSpPr>
      <dsp:spPr>
        <a:xfrm>
          <a:off x="276881" y="2496027"/>
          <a:ext cx="503420" cy="503420"/>
        </a:xfrm>
        <a:prstGeom prst="rect">
          <a:avLst/>
        </a:prstGeom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8B338477-D037-4486-88D8-42F29B24230E}">
      <dsp:nvSpPr>
        <dsp:cNvPr id="0" name=""/>
        <dsp:cNvSpPr/>
      </dsp:nvSpPr>
      <dsp:spPr>
        <a:xfrm>
          <a:off x="1057183" y="2290082"/>
          <a:ext cx="9458416" cy="91531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6870" tIns="96870" rIns="96870" bIns="96870" numCol="1" spcCol="1270" anchor="ctr" anchorCtr="0">
          <a:noAutofit/>
        </a:bodyPr>
        <a:lstStyle/>
        <a:p>
          <a:pPr marL="0" lvl="0" indent="0" algn="l" defTabSz="622300">
            <a:lnSpc>
              <a:spcPct val="10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/>
            <a:t>At the Roadblock location, you’ll receive a new envelope containing a “Roadblock Task”. Your team will select one team member to complete a task alone while the rest of your team completes a different task. Successful completion of both tasks provides you with a final envelope containing a “Route Info clue” leading to the last location and victory</a:t>
          </a:r>
        </a:p>
      </dsp:txBody>
      <dsp:txXfrm>
        <a:off x="1057183" y="2290082"/>
        <a:ext cx="9458416" cy="915310"/>
      </dsp:txXfrm>
    </dsp:sp>
    <dsp:sp modelId="{272A4618-5156-4AD2-830F-51979F049B96}">
      <dsp:nvSpPr>
        <dsp:cNvPr id="0" name=""/>
        <dsp:cNvSpPr/>
      </dsp:nvSpPr>
      <dsp:spPr>
        <a:xfrm>
          <a:off x="0" y="3436027"/>
          <a:ext cx="10515600" cy="915310"/>
        </a:xfrm>
        <a:prstGeom prst="roundRect">
          <a:avLst>
            <a:gd name="adj" fmla="val 10000"/>
          </a:avLst>
        </a:prstGeom>
        <a:solidFill>
          <a:schemeClr val="accent1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83639282-8798-476B-AA77-1A3116296AAE}">
      <dsp:nvSpPr>
        <dsp:cNvPr id="0" name=""/>
        <dsp:cNvSpPr/>
      </dsp:nvSpPr>
      <dsp:spPr>
        <a:xfrm>
          <a:off x="276881" y="3640166"/>
          <a:ext cx="503420" cy="503420"/>
        </a:xfrm>
        <a:prstGeom prst="rect">
          <a:avLst/>
        </a:prstGeom>
        <a:blipFill>
          <a:blip xmlns:r="http://schemas.openxmlformats.org/officeDocument/2006/relationships"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327B5D54-C83C-4F97-87E1-B222958CFDA3}">
      <dsp:nvSpPr>
        <dsp:cNvPr id="0" name=""/>
        <dsp:cNvSpPr/>
      </dsp:nvSpPr>
      <dsp:spPr>
        <a:xfrm>
          <a:off x="1057183" y="3434221"/>
          <a:ext cx="9458416" cy="91531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6870" tIns="96870" rIns="96870" bIns="96870" numCol="1" spcCol="1270" anchor="ctr" anchorCtr="0">
          <a:noAutofit/>
        </a:bodyPr>
        <a:lstStyle/>
        <a:p>
          <a:pPr marL="0" lvl="0" indent="0" algn="l" defTabSz="622300">
            <a:lnSpc>
              <a:spcPct val="10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/>
            <a:t>Fastest team wins!</a:t>
          </a:r>
        </a:p>
      </dsp:txBody>
      <dsp:txXfrm>
        <a:off x="1057183" y="3434221"/>
        <a:ext cx="9458416" cy="915310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74FAACA5-8267-445A-92A1-A1CC49F53C3F}">
      <dsp:nvSpPr>
        <dsp:cNvPr id="0" name=""/>
        <dsp:cNvSpPr/>
      </dsp:nvSpPr>
      <dsp:spPr>
        <a:xfrm>
          <a:off x="0" y="531"/>
          <a:ext cx="10515600" cy="1244702"/>
        </a:xfrm>
        <a:prstGeom prst="roundRect">
          <a:avLst>
            <a:gd name="adj" fmla="val 10000"/>
          </a:avLst>
        </a:prstGeom>
        <a:solidFill>
          <a:schemeClr val="accent2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550A4141-48BC-409E-9B99-931E91A9F6DA}">
      <dsp:nvSpPr>
        <dsp:cNvPr id="0" name=""/>
        <dsp:cNvSpPr/>
      </dsp:nvSpPr>
      <dsp:spPr>
        <a:xfrm>
          <a:off x="376522" y="280590"/>
          <a:ext cx="684586" cy="684586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a:blipFill>
        <a:ln w="1905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D32901E1-353F-4A35-974D-F43924C9D9C2}">
      <dsp:nvSpPr>
        <dsp:cNvPr id="0" name=""/>
        <dsp:cNvSpPr/>
      </dsp:nvSpPr>
      <dsp:spPr>
        <a:xfrm>
          <a:off x="1437631" y="531"/>
          <a:ext cx="9077968" cy="124470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31731" tIns="131731" rIns="131731" bIns="131731" numCol="1" spcCol="1270" anchor="ctr" anchorCtr="0">
          <a:noAutofit/>
        </a:bodyPr>
        <a:lstStyle/>
        <a:p>
          <a:pPr marL="0" lvl="0" indent="0" algn="l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500" kern="1200"/>
            <a:t>Your trip will be burdened with time delays if you perform poorly on tasks. Do tasks accurately the first time to avoid these. </a:t>
          </a:r>
        </a:p>
      </dsp:txBody>
      <dsp:txXfrm>
        <a:off x="1437631" y="531"/>
        <a:ext cx="9077968" cy="1244702"/>
      </dsp:txXfrm>
    </dsp:sp>
    <dsp:sp modelId="{B7D69664-53FD-488D-82E6-9E9B1196AB05}">
      <dsp:nvSpPr>
        <dsp:cNvPr id="0" name=""/>
        <dsp:cNvSpPr/>
      </dsp:nvSpPr>
      <dsp:spPr>
        <a:xfrm>
          <a:off x="0" y="1556410"/>
          <a:ext cx="10515600" cy="1244702"/>
        </a:xfrm>
        <a:prstGeom prst="roundRect">
          <a:avLst>
            <a:gd name="adj" fmla="val 10000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22510EE0-CE93-458A-B76B-100B2ABB678E}">
      <dsp:nvSpPr>
        <dsp:cNvPr id="0" name=""/>
        <dsp:cNvSpPr/>
      </dsp:nvSpPr>
      <dsp:spPr>
        <a:xfrm>
          <a:off x="376522" y="1836468"/>
          <a:ext cx="684586" cy="684586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a:blipFill>
        <a:ln w="1905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19AE23B1-1AC4-43F1-A5E3-50FC03D692F5}">
      <dsp:nvSpPr>
        <dsp:cNvPr id="0" name=""/>
        <dsp:cNvSpPr/>
      </dsp:nvSpPr>
      <dsp:spPr>
        <a:xfrm>
          <a:off x="1437631" y="1556410"/>
          <a:ext cx="9077968" cy="124470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31731" tIns="131731" rIns="131731" bIns="131731" numCol="1" spcCol="1270" anchor="ctr" anchorCtr="0">
          <a:noAutofit/>
        </a:bodyPr>
        <a:lstStyle/>
        <a:p>
          <a:pPr marL="0" lvl="0" indent="0" algn="l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500" kern="1200"/>
            <a:t>Work together! Your shared expertise will carry you further and faster. </a:t>
          </a:r>
        </a:p>
      </dsp:txBody>
      <dsp:txXfrm>
        <a:off x="1437631" y="1556410"/>
        <a:ext cx="9077968" cy="1244702"/>
      </dsp:txXfrm>
    </dsp:sp>
    <dsp:sp modelId="{0DF97F09-E805-4D59-8EE4-D17123A48771}">
      <dsp:nvSpPr>
        <dsp:cNvPr id="0" name=""/>
        <dsp:cNvSpPr/>
      </dsp:nvSpPr>
      <dsp:spPr>
        <a:xfrm>
          <a:off x="0" y="3112289"/>
          <a:ext cx="10515600" cy="1244702"/>
        </a:xfrm>
        <a:prstGeom prst="roundRect">
          <a:avLst>
            <a:gd name="adj" fmla="val 10000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BE9FBA7-0412-473D-86D4-FEEA49CE56EA}">
      <dsp:nvSpPr>
        <dsp:cNvPr id="0" name=""/>
        <dsp:cNvSpPr/>
      </dsp:nvSpPr>
      <dsp:spPr>
        <a:xfrm>
          <a:off x="376522" y="3392347"/>
          <a:ext cx="684586" cy="684586"/>
        </a:xfrm>
        <a:prstGeom prst="rect">
          <a:avLst/>
        </a:prstGeom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a:blipFill>
        <a:ln w="1905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62947D69-2CCC-44D6-ABFE-E016CC4509A6}">
      <dsp:nvSpPr>
        <dsp:cNvPr id="0" name=""/>
        <dsp:cNvSpPr/>
      </dsp:nvSpPr>
      <dsp:spPr>
        <a:xfrm>
          <a:off x="1437631" y="3112289"/>
          <a:ext cx="9077968" cy="124470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31731" tIns="131731" rIns="131731" bIns="131731" numCol="1" spcCol="1270" anchor="ctr" anchorCtr="0">
          <a:noAutofit/>
        </a:bodyPr>
        <a:lstStyle/>
        <a:p>
          <a:pPr marL="0" lvl="0" indent="0" algn="l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500" kern="1200"/>
            <a:t>You cannot look up answers electronically unless instructed to do so. Rule breakers receive time delays!</a:t>
          </a:r>
        </a:p>
      </dsp:txBody>
      <dsp:txXfrm>
        <a:off x="1437631" y="3112289"/>
        <a:ext cx="9077968" cy="1244702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18/2/layout/IconVerticalSolidList">
  <dgm:title val="Icon Vertical Solid List"/>
  <dgm:desc val="Use to show a series of visuals from top to bottom with Level 1 or Level 1 and Level 2 text grouped in a shape. Works best with icons or small pictures with lengthier descriptions."/>
  <dgm:catLst>
    <dgm:cat type="icon" pri="5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 useDef="1">
    <dgm:dataModel>
      <dgm:ptLst/>
      <dgm:bg/>
      <dgm:whole/>
    </dgm:dataModel>
  </dgm:clrData>
  <dgm:layoutNode name="root">
    <dgm:varLst>
      <dgm:dir/>
      <dgm:resizeHandles val="exact"/>
    </dgm:varLst>
    <dgm:choose name="Name0">
      <dgm:if name="Name1" axis="self" func="var" arg="dir" op="equ" val="norm">
        <dgm:alg type="lin">
          <dgm:param type="linDir" val="fromT"/>
          <dgm:param type="nodeHorzAlign" val="l"/>
        </dgm:alg>
      </dgm:if>
      <dgm:else name="Name2">
        <dgm:alg type="lin">
          <dgm:param type="linDir" val="fromT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hoose name="Name3">
      <dgm:if name="Name4" axis="ch" ptType="node" func="cnt" op="lte" val="3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25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if>
      <dgm:if name="Name5" axis="ch" ptType="node" func="cnt" op="lte" val="4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22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if>
      <dgm:if name="Name6" axis="ch" ptType="node" func="cnt" op="lte" val="6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19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if>
      <dgm:else name="Name7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16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else>
    </dgm:choose>
    <dgm:ruleLst>
      <dgm:rule type="h" for="ch" forName="compNode" val="0" fact="NaN" max="NaN"/>
    </dgm:ruleLst>
    <dgm:forEach name="Name8" axis="ch" ptType="node">
      <dgm:layoutNode name="compNode">
        <dgm:alg type="composite"/>
        <dgm:shape xmlns:r="http://schemas.openxmlformats.org/officeDocument/2006/relationships" r:blip="">
          <dgm:adjLst/>
        </dgm:shape>
        <dgm:presOf axis="self"/>
        <dgm:choose name="Name9">
          <dgm:if name="Name10" axis="ch" ptType="node" func="cnt" op="gte" val="1">
            <dgm:constrLst>
              <dgm:constr type="w" for="ch" forName="bgRect" refType="w"/>
              <dgm:constr type="h" for="ch" forName="bgRect" refType="h"/>
              <dgm:constr type="l" for="ch" forName="bgRect"/>
              <dgm:constr type="t" for="ch" forName="bgRect"/>
              <dgm:constr type="h" for="ch" forName="iconRect" refType="h" fact="0.55"/>
              <dgm:constr type="w" for="ch" forName="iconRect" refType="h" refFor="ch" refForName="iconRect"/>
              <dgm:constr type="l" for="ch" forName="iconRect" refType="h" refFor="ch" refForName="iconRect" fact="0.55"/>
              <dgm:constr type="ctrY" for="ch" forName="iconRect" refType="ctrY" refFor="ch" refForName="bgRect"/>
              <dgm:constr type="w" for="ch" forName="spaceRect" refType="l" refFor="ch" refForName="iconRect"/>
              <dgm:constr type="h" for="ch" forName="spaceRect" refType="h"/>
              <dgm:constr type="l" for="ch" forName="spaceRect" refType="r" refFor="ch" refForName="iconRect"/>
              <dgm:constr type="t" for="ch" forName="spaceRect"/>
              <dgm:constr type="w" for="ch" forName="parTx" refType="w" fact="0.45"/>
              <dgm:constr type="h" for="ch" forName="parTx" refType="h"/>
              <dgm:constr type="l" for="ch" forName="parTx" refType="r" refFor="ch" refForName="spaceRect"/>
              <dgm:constr type="t" for="ch" forName="parTx"/>
              <dgm:constr type="h" for="ch" forName="desTx" refType="h"/>
              <dgm:constr type="l" for="ch" forName="desTx" refType="r" refFor="ch" refForName="parTx"/>
              <dgm:constr type="t" for="ch" forName="desTx"/>
            </dgm:constrLst>
          </dgm:if>
          <dgm:else name="Name11">
            <dgm:constrLst>
              <dgm:constr type="w" for="ch" forName="bgRect" refType="w"/>
              <dgm:constr type="h" for="ch" forName="bgRect" refType="h"/>
              <dgm:constr type="l" for="ch" forName="bgRect"/>
              <dgm:constr type="t" for="ch" forName="bgRect"/>
              <dgm:constr type="h" for="ch" forName="iconRect" refType="h" fact="0.55"/>
              <dgm:constr type="w" for="ch" forName="iconRect" refType="h" refFor="ch" refForName="iconRect"/>
              <dgm:constr type="l" for="ch" forName="iconRect" refType="h" refFor="ch" refForName="iconRect" fact="0.55"/>
              <dgm:constr type="ctrY" for="ch" forName="iconRect" refType="ctrY" refFor="ch" refForName="bgRect"/>
              <dgm:constr type="w" for="ch" forName="spaceRect" refType="l" refFor="ch" refForName="iconRect"/>
              <dgm:constr type="h" for="ch" forName="spaceRect" refType="h"/>
              <dgm:constr type="l" for="ch" forName="spaceRect" refType="r" refFor="ch" refForName="iconRect"/>
              <dgm:constr type="t" for="ch" forName="spaceRect"/>
              <dgm:constr type="h" for="ch" forName="parTx" refType="h"/>
              <dgm:constr type="l" for="ch" forName="parTx" refType="r" refFor="ch" refForName="spaceRect"/>
              <dgm:constr type="t" for="ch" forName="parTx"/>
            </dgm:constrLst>
          </dgm:else>
        </dgm:choose>
        <dgm:ruleLst>
          <dgm:rule type="h" val="INF" fact="NaN" max="NaN"/>
        </dgm:ruleLst>
        <dgm:layoutNode name="bgRect" styleLbl="bgShp">
          <dgm:alg type="sp"/>
          <dgm:shape xmlns:r="http://schemas.openxmlformats.org/officeDocument/2006/relationships" type="roundRect" r:blip="">
            <dgm:adjLst>
              <dgm:adj idx="1" val="0.1"/>
            </dgm:adjLst>
          </dgm:shape>
          <dgm:presOf/>
          <dgm:constrLst/>
          <dgm:ruleLst/>
        </dgm:layoutNode>
        <dgm:layoutNode name="iconRect" styleLbl="node1">
          <dgm:alg type="sp"/>
          <dgm:shape xmlns:r="http://schemas.openxmlformats.org/officeDocument/2006/relationships" type="rect" r:blip="" blipPhldr="1">
            <dgm:adjLst/>
          </dgm:shape>
          <dgm:presOf/>
          <dgm:constrLst/>
          <dgm:ruleLst/>
        </dgm:layoutNode>
        <dgm:layoutNode name="spaceRect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  <dgm:layoutNode name="parTx" styleLbl="revTx">
          <dgm:varLst>
            <dgm:chMax val="0"/>
            <dgm:chPref val="0"/>
          </dgm:varLst>
          <dgm:alg type="tx">
            <dgm:param type="txAnchorVert" val="mid"/>
            <dgm:param type="parTxLTRAlign" val="l"/>
            <dgm:param type="shpTxLTRAlignCh" val="l"/>
            <dgm:param type="parTxRTLAlign" val="r"/>
            <dgm:param type="shpTxRTLAlignCh" val="r"/>
          </dgm:alg>
          <dgm:shape xmlns:r="http://schemas.openxmlformats.org/officeDocument/2006/relationships" type="rect" r:blip="">
            <dgm:adjLst/>
          </dgm:shape>
          <dgm:presOf axis="self" ptType="node"/>
          <dgm:constrLst>
            <dgm:constr type="lMarg" refType="h" fact="0.3"/>
            <dgm:constr type="rMarg" refType="h" fact="0.3"/>
            <dgm:constr type="tMarg" refType="h" fact="0.3"/>
            <dgm:constr type="bMarg" refType="h" fact="0.3"/>
          </dgm:constrLst>
          <dgm:ruleLst>
            <dgm:rule type="primFontSz" val="14" fact="NaN" max="NaN"/>
            <dgm:rule type="h" val="INF" fact="NaN" max="NaN"/>
          </dgm:ruleLst>
        </dgm:layoutNode>
        <dgm:choose name="Name12">
          <dgm:if name="Name13" axis="ch" ptType="node" func="cnt" op="gte" val="1">
            <dgm:layoutNode name="desTx" styleLbl="revTx">
              <dgm:varLst/>
              <dgm:alg type="tx">
                <dgm:param type="txAnchorVertCh" val="mid"/>
                <dgm:param type="parTxLTRAlign" val="l"/>
                <dgm:param type="shpTxLTRAlignCh" val="l"/>
                <dgm:param type="parTxRTLAlign" val="r"/>
                <dgm:param type="shpTxRTLAlignCh" val="r"/>
                <dgm:param type="stBulletLvl" val="0"/>
              </dgm:alg>
              <dgm:shape xmlns:r="http://schemas.openxmlformats.org/officeDocument/2006/relationships" type="rect" r:blip="">
                <dgm:adjLst/>
              </dgm:shape>
              <dgm:presOf axis="des" ptType="node"/>
              <dgm:constrLst>
                <dgm:constr type="primFontSz" val="18"/>
                <dgm:constr type="secFontSz" refType="primFontSz"/>
                <dgm:constr type="lMarg" refType="h" fact="0.3"/>
                <dgm:constr type="rMarg" refType="h" fact="0.3"/>
                <dgm:constr type="tMarg" refType="h" fact="0.3"/>
                <dgm:constr type="bMarg" refType="h" fact="0.3"/>
              </dgm:constrLst>
              <dgm:ruleLst>
                <dgm:rule type="primFontSz" val="11" fact="NaN" max="NaN"/>
              </dgm:ruleLst>
            </dgm:layoutNode>
          </dgm:if>
          <dgm:else name="Name14"/>
        </dgm:choose>
      </dgm:layoutNode>
      <dgm:forEach name="Name15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  <dgm:extLst>
    <a:ext uri="{68A01E43-0DF5-4B5B-8FA6-DAF915123BFB}">
      <dgm1612:lstStyle xmlns:dgm1612="http://schemas.microsoft.com/office/drawing/2016/12/diagram">
        <a:lvl1pPr>
          <a:lnSpc>
            <a:spcPct val="100000"/>
          </a:lnSpc>
        </a:lvl1pPr>
        <a:lvl2pPr>
          <a:lnSpc>
            <a:spcPct val="100000"/>
          </a:lnSpc>
        </a:lvl2pPr>
      </dgm1612:lstStyle>
    </a:ext>
  </dgm:extLst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18/2/layout/IconVerticalSolidList">
  <dgm:title val="Icon Vertical Solid List"/>
  <dgm:desc val="Use to show a series of visuals from top to bottom with Level 1 or Level 1 and Level 2 text grouped in a shape. Works best with icons or small pictures with lengthier descriptions."/>
  <dgm:catLst>
    <dgm:cat type="icon" pri="5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 useDef="1">
    <dgm:dataModel>
      <dgm:ptLst/>
      <dgm:bg/>
      <dgm:whole/>
    </dgm:dataModel>
  </dgm:clrData>
  <dgm:layoutNode name="root">
    <dgm:varLst>
      <dgm:dir/>
      <dgm:resizeHandles val="exact"/>
    </dgm:varLst>
    <dgm:choose name="Name0">
      <dgm:if name="Name1" axis="self" func="var" arg="dir" op="equ" val="norm">
        <dgm:alg type="lin">
          <dgm:param type="linDir" val="fromT"/>
          <dgm:param type="nodeHorzAlign" val="l"/>
        </dgm:alg>
      </dgm:if>
      <dgm:else name="Name2">
        <dgm:alg type="lin">
          <dgm:param type="linDir" val="fromT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hoose name="Name3">
      <dgm:if name="Name4" axis="ch" ptType="node" func="cnt" op="lte" val="3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25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if>
      <dgm:if name="Name5" axis="ch" ptType="node" func="cnt" op="lte" val="4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22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if>
      <dgm:if name="Name6" axis="ch" ptType="node" func="cnt" op="lte" val="6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19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if>
      <dgm:else name="Name7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16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else>
    </dgm:choose>
    <dgm:ruleLst>
      <dgm:rule type="h" for="ch" forName="compNode" val="0" fact="NaN" max="NaN"/>
    </dgm:ruleLst>
    <dgm:forEach name="Name8" axis="ch" ptType="node">
      <dgm:layoutNode name="compNode">
        <dgm:alg type="composite"/>
        <dgm:shape xmlns:r="http://schemas.openxmlformats.org/officeDocument/2006/relationships" r:blip="">
          <dgm:adjLst/>
        </dgm:shape>
        <dgm:presOf axis="self"/>
        <dgm:choose name="Name9">
          <dgm:if name="Name10" axis="ch" ptType="node" func="cnt" op="gte" val="1">
            <dgm:constrLst>
              <dgm:constr type="w" for="ch" forName="bgRect" refType="w"/>
              <dgm:constr type="h" for="ch" forName="bgRect" refType="h"/>
              <dgm:constr type="l" for="ch" forName="bgRect"/>
              <dgm:constr type="t" for="ch" forName="bgRect"/>
              <dgm:constr type="h" for="ch" forName="iconRect" refType="h" fact="0.55"/>
              <dgm:constr type="w" for="ch" forName="iconRect" refType="h" refFor="ch" refForName="iconRect"/>
              <dgm:constr type="l" for="ch" forName="iconRect" refType="h" refFor="ch" refForName="iconRect" fact="0.55"/>
              <dgm:constr type="ctrY" for="ch" forName="iconRect" refType="ctrY" refFor="ch" refForName="bgRect"/>
              <dgm:constr type="w" for="ch" forName="spaceRect" refType="l" refFor="ch" refForName="iconRect"/>
              <dgm:constr type="h" for="ch" forName="spaceRect" refType="h"/>
              <dgm:constr type="l" for="ch" forName="spaceRect" refType="r" refFor="ch" refForName="iconRect"/>
              <dgm:constr type="t" for="ch" forName="spaceRect"/>
              <dgm:constr type="w" for="ch" forName="parTx" refType="w" fact="0.45"/>
              <dgm:constr type="h" for="ch" forName="parTx" refType="h"/>
              <dgm:constr type="l" for="ch" forName="parTx" refType="r" refFor="ch" refForName="spaceRect"/>
              <dgm:constr type="t" for="ch" forName="parTx"/>
              <dgm:constr type="h" for="ch" forName="desTx" refType="h"/>
              <dgm:constr type="l" for="ch" forName="desTx" refType="r" refFor="ch" refForName="parTx"/>
              <dgm:constr type="t" for="ch" forName="desTx"/>
            </dgm:constrLst>
          </dgm:if>
          <dgm:else name="Name11">
            <dgm:constrLst>
              <dgm:constr type="w" for="ch" forName="bgRect" refType="w"/>
              <dgm:constr type="h" for="ch" forName="bgRect" refType="h"/>
              <dgm:constr type="l" for="ch" forName="bgRect"/>
              <dgm:constr type="t" for="ch" forName="bgRect"/>
              <dgm:constr type="h" for="ch" forName="iconRect" refType="h" fact="0.55"/>
              <dgm:constr type="w" for="ch" forName="iconRect" refType="h" refFor="ch" refForName="iconRect"/>
              <dgm:constr type="l" for="ch" forName="iconRect" refType="h" refFor="ch" refForName="iconRect" fact="0.55"/>
              <dgm:constr type="ctrY" for="ch" forName="iconRect" refType="ctrY" refFor="ch" refForName="bgRect"/>
              <dgm:constr type="w" for="ch" forName="spaceRect" refType="l" refFor="ch" refForName="iconRect"/>
              <dgm:constr type="h" for="ch" forName="spaceRect" refType="h"/>
              <dgm:constr type="l" for="ch" forName="spaceRect" refType="r" refFor="ch" refForName="iconRect"/>
              <dgm:constr type="t" for="ch" forName="spaceRect"/>
              <dgm:constr type="h" for="ch" forName="parTx" refType="h"/>
              <dgm:constr type="l" for="ch" forName="parTx" refType="r" refFor="ch" refForName="spaceRect"/>
              <dgm:constr type="t" for="ch" forName="parTx"/>
            </dgm:constrLst>
          </dgm:else>
        </dgm:choose>
        <dgm:ruleLst>
          <dgm:rule type="h" val="INF" fact="NaN" max="NaN"/>
        </dgm:ruleLst>
        <dgm:layoutNode name="bgRect" styleLbl="bgShp">
          <dgm:alg type="sp"/>
          <dgm:shape xmlns:r="http://schemas.openxmlformats.org/officeDocument/2006/relationships" type="roundRect" r:blip="">
            <dgm:adjLst>
              <dgm:adj idx="1" val="0.1"/>
            </dgm:adjLst>
          </dgm:shape>
          <dgm:presOf/>
          <dgm:constrLst/>
          <dgm:ruleLst/>
        </dgm:layoutNode>
        <dgm:layoutNode name="iconRect" styleLbl="node1">
          <dgm:alg type="sp"/>
          <dgm:shape xmlns:r="http://schemas.openxmlformats.org/officeDocument/2006/relationships" type="rect" r:blip="" blipPhldr="1">
            <dgm:adjLst/>
          </dgm:shape>
          <dgm:presOf/>
          <dgm:constrLst/>
          <dgm:ruleLst/>
        </dgm:layoutNode>
        <dgm:layoutNode name="spaceRect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  <dgm:layoutNode name="parTx" styleLbl="revTx">
          <dgm:varLst>
            <dgm:chMax val="0"/>
            <dgm:chPref val="0"/>
          </dgm:varLst>
          <dgm:alg type="tx">
            <dgm:param type="txAnchorVert" val="mid"/>
            <dgm:param type="parTxLTRAlign" val="l"/>
            <dgm:param type="shpTxLTRAlignCh" val="l"/>
            <dgm:param type="parTxRTLAlign" val="r"/>
            <dgm:param type="shpTxRTLAlignCh" val="r"/>
          </dgm:alg>
          <dgm:shape xmlns:r="http://schemas.openxmlformats.org/officeDocument/2006/relationships" type="rect" r:blip="">
            <dgm:adjLst/>
          </dgm:shape>
          <dgm:presOf axis="self" ptType="node"/>
          <dgm:constrLst>
            <dgm:constr type="lMarg" refType="h" fact="0.3"/>
            <dgm:constr type="rMarg" refType="h" fact="0.3"/>
            <dgm:constr type="tMarg" refType="h" fact="0.3"/>
            <dgm:constr type="bMarg" refType="h" fact="0.3"/>
          </dgm:constrLst>
          <dgm:ruleLst>
            <dgm:rule type="primFontSz" val="14" fact="NaN" max="NaN"/>
            <dgm:rule type="h" val="INF" fact="NaN" max="NaN"/>
          </dgm:ruleLst>
        </dgm:layoutNode>
        <dgm:choose name="Name12">
          <dgm:if name="Name13" axis="ch" ptType="node" func="cnt" op="gte" val="1">
            <dgm:layoutNode name="desTx" styleLbl="revTx">
              <dgm:varLst/>
              <dgm:alg type="tx">
                <dgm:param type="txAnchorVertCh" val="mid"/>
                <dgm:param type="parTxLTRAlign" val="l"/>
                <dgm:param type="shpTxLTRAlignCh" val="l"/>
                <dgm:param type="parTxRTLAlign" val="r"/>
                <dgm:param type="shpTxRTLAlignCh" val="r"/>
                <dgm:param type="stBulletLvl" val="0"/>
              </dgm:alg>
              <dgm:shape xmlns:r="http://schemas.openxmlformats.org/officeDocument/2006/relationships" type="rect" r:blip="">
                <dgm:adjLst/>
              </dgm:shape>
              <dgm:presOf axis="des" ptType="node"/>
              <dgm:constrLst>
                <dgm:constr type="primFontSz" val="18"/>
                <dgm:constr type="secFontSz" refType="primFontSz"/>
                <dgm:constr type="lMarg" refType="h" fact="0.3"/>
                <dgm:constr type="rMarg" refType="h" fact="0.3"/>
                <dgm:constr type="tMarg" refType="h" fact="0.3"/>
                <dgm:constr type="bMarg" refType="h" fact="0.3"/>
              </dgm:constrLst>
              <dgm:ruleLst>
                <dgm:rule type="primFontSz" val="11" fact="NaN" max="NaN"/>
              </dgm:ruleLst>
            </dgm:layoutNode>
          </dgm:if>
          <dgm:else name="Name14"/>
        </dgm:choose>
      </dgm:layoutNode>
      <dgm:forEach name="Name15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  <dgm:extLst>
    <a:ext uri="{68A01E43-0DF5-4B5B-8FA6-DAF915123BFB}">
      <dgm1612:lstStyle xmlns:dgm1612="http://schemas.microsoft.com/office/drawing/2016/12/diagram">
        <a:lvl1pPr>
          <a:lnSpc>
            <a:spcPct val="100000"/>
          </a:lnSpc>
        </a:lvl1pPr>
        <a:lvl2pPr>
          <a:lnSpc>
            <a:spcPct val="100000"/>
          </a:lnSpc>
        </a:lvl2pPr>
      </dgm1612:lstStyle>
    </a:ext>
  </dgm:extLst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8626F5-B569-4044-A645-AC8D17514FA4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F2FC9D-36D0-2144-AB51-CB3A904DD8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5171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6F2FC9D-36D0-2144-AB51-CB3A904DD86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3461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7D5FF0-6B1C-20EF-4D35-6B33CF5EAE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C8CB98-1AE1-75F0-1E79-0DA814E789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31A53A-C246-1942-76FC-1B8F23ECB7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CEF6C-AA54-594E-8B39-CC61639495F6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EC1268-C487-4AB5-0F38-4D554D3F23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0E6DDD-CA78-680C-64AA-B0A7AFBB27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89A9E-C553-6847-A98F-B608624F3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33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729C0F-480B-EC9E-DF9C-DD2EDA6CAD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9095A2D-DD1C-1993-729A-83B8BF096E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F12C44-F0D5-CE89-E706-BFA7BF67B6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CEF6C-AA54-594E-8B39-CC61639495F6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728B79-EC72-B89C-DE84-CAEE9E3FA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54DE7D-EC81-DBD7-9FC3-092AB6C83A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89A9E-C553-6847-A98F-B608624F3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415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E64FBA0-8AD3-EFAB-EAB1-D4E658369B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5AD381-C004-D7D0-2144-F7228F0887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936712-D927-1CD4-71FA-E89E8A28F8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CEF6C-AA54-594E-8B39-CC61639495F6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0ECAA8-1E99-FC40-C00B-FE908B450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AD9CF2-610D-7D8E-FC49-E41387E129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89A9E-C553-6847-A98F-B608624F3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1257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E256EC-C9C8-0BF1-126E-BD809D1432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10C43A-02D0-A797-2DF5-F40103AE5B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45872C-E18C-8228-5A9A-D58CB44E1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CEF6C-AA54-594E-8B39-CC61639495F6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B35DFB-3E91-7EB7-15AA-D731B805B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996A34-D69A-E0B7-DCAA-5F9342978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89A9E-C553-6847-A98F-B608624F3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224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A53027-6AA2-5FA9-BBF8-4BFA171D5C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E1ED3D-DF87-C880-F7D2-C466002544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2E4D90-6089-7C3E-710B-A3A8723E4E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CEF6C-AA54-594E-8B39-CC61639495F6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D4853E-7405-85E0-E804-66E2321EAC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32B920-8A6D-6FC6-6693-EAF638D9D3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89A9E-C553-6847-A98F-B608624F3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6626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53B5A3-D3F6-BF84-01FE-00E986B007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F874ED-293F-74CB-2952-6B26383A92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B51ABE-2492-EA56-7FEE-CA696C912C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89D4F6-C8F3-0953-E095-EAE404ADE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CEF6C-AA54-594E-8B39-CC61639495F6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D68EC8-57E4-36A8-179A-5E0536C24D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33F223-1C78-8379-8894-AA49EDABD7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89A9E-C553-6847-A98F-B608624F3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709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F8798A-B6FA-D01F-159C-6FF79C0484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447F72-824A-07C7-3B22-CE039C795D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46C320-A763-6534-90FC-65253FA9CE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D79FB60-583C-2F68-2DD6-FCC14E8F2D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59A8437-D5E0-5072-5ACD-F2DBF01EA9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E1B64B1-FB43-4754-967F-ABD917171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CEF6C-AA54-594E-8B39-CC61639495F6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0A75BE-57B9-8ECA-3376-0C26AC2CE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6641B5D-0F95-D214-3EBF-5FC7A3543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89A9E-C553-6847-A98F-B608624F3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874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7DA1F8-5E57-263D-98D9-89751B2588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A562C4-72CE-2341-C00A-82B94D831E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CEF6C-AA54-594E-8B39-CC61639495F6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7549256-8213-CDFE-A114-F62F4A20D1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956EE2A-E1C8-AC6F-B9AB-916F12421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89A9E-C553-6847-A98F-B608624F3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755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F00BE2D-060F-4157-D552-9EE089503B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CEF6C-AA54-594E-8B39-CC61639495F6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B6E39BE-1940-EDC6-9E66-CB06A9857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6A96101-64E6-296A-4FDA-8A02AD989A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89A9E-C553-6847-A98F-B608624F3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1960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581337-C055-3909-2F58-93F5E6618D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F18DC2-ACE4-FB8B-8AA1-76B6FE1A1C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7E3261-E0F1-1A0D-AA98-56019126F9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B79BB6-3979-519B-F89F-E0B97BE46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CEF6C-AA54-594E-8B39-CC61639495F6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01AD87-E28D-20A0-0670-68F6F37662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D29140-ABBB-3CF4-2E0C-E891310F71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89A9E-C553-6847-A98F-B608624F3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557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C72BD8-CEE4-13D5-4EAD-BECAF3917C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1781793-758D-41DA-414E-582ADB77BEE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A506A4-F6F5-440B-FE01-0960BA1AEB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78E1F6-D294-ED10-7B17-8D04923CDE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CEF6C-AA54-594E-8B39-CC61639495F6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FB3040-26ED-C9D8-4A22-AA0966CB36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C973DA-5D28-792E-0DB6-17E9CB2E63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89A9E-C553-6847-A98F-B608624F3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870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BB95A34-B585-BCD8-AA15-D6C88614AE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11B6BF-6D49-259B-A9D1-33556D6959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DE27D8-8302-ED20-39D4-E0D776D90E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B2CEF6C-AA54-594E-8B39-CC61639495F6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DF8167-EC90-4056-F770-83B974AF4C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45C775-AED6-BDED-570C-BC3C4AFBED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6D89A9E-C553-6847-A98F-B608624F3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318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sv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2" Type="http://schemas.openxmlformats.org/officeDocument/2006/relationships/diagramData" Target="../diagrams/data2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2.xml"/><Relationship Id="rId5" Type="http://schemas.openxmlformats.org/officeDocument/2006/relationships/diagramColors" Target="../diagrams/colors2.xml"/><Relationship Id="rId4" Type="http://schemas.openxmlformats.org/officeDocument/2006/relationships/diagramQuickStyle" Target="../diagrams/quickStyle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74751229-0244-4FBB-BED1-407467F4C95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BFC6D9D-4BAE-FDE5-3F1A-68BC43B2E1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197101" y="1067793"/>
            <a:ext cx="6210629" cy="3165045"/>
          </a:xfrm>
        </p:spPr>
        <p:txBody>
          <a:bodyPr anchor="b">
            <a:normAutofit/>
          </a:bodyPr>
          <a:lstStyle/>
          <a:p>
            <a:pPr algn="l"/>
            <a:r>
              <a:rPr lang="en-US" sz="7000" b="1" dirty="0">
                <a:solidFill>
                  <a:srgbClr val="FF0000"/>
                </a:solidFill>
              </a:rPr>
              <a:t>The EM-</a:t>
            </a:r>
            <a:r>
              <a:rPr lang="en-US" sz="7000" b="1" dirty="0" err="1">
                <a:solidFill>
                  <a:srgbClr val="FF0000"/>
                </a:solidFill>
              </a:rPr>
              <a:t>azing</a:t>
            </a:r>
            <a:r>
              <a:rPr lang="en-US" sz="7000" b="1" dirty="0">
                <a:solidFill>
                  <a:srgbClr val="FF0000"/>
                </a:solidFill>
              </a:rPr>
              <a:t> Race</a:t>
            </a:r>
          </a:p>
        </p:txBody>
      </p:sp>
      <p:pic>
        <p:nvPicPr>
          <p:cNvPr id="6" name="Graphic 5" descr="Run">
            <a:extLst>
              <a:ext uri="{FF2B5EF4-FFF2-40B4-BE49-F238E27FC236}">
                <a16:creationId xmlns:a16="http://schemas.microsoft.com/office/drawing/2014/main" id="{F030215F-F141-372E-8100-24FC51A0BE8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17549" y="2776619"/>
            <a:ext cx="1289051" cy="1289051"/>
          </a:xfrm>
          <a:prstGeom prst="rect">
            <a:avLst/>
          </a:prstGeom>
        </p:spPr>
      </p:pic>
      <p:pic>
        <p:nvPicPr>
          <p:cNvPr id="8" name="Graphic 7" descr="Run">
            <a:extLst>
              <a:ext uri="{FF2B5EF4-FFF2-40B4-BE49-F238E27FC236}">
                <a16:creationId xmlns:a16="http://schemas.microsoft.com/office/drawing/2014/main" id="{8D17FFB6-F39E-4248-95AE-B9C68AD46A1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Grp="1" noRot="1" noChangeAspect="1" noMove="1" noResize="1" noEditPoints="1" noAdjustHandles="1" noChangeArrowheads="1" noChangeShapeType="1" noCrop="1"/>
          </p:cNvPic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PicPr>
        <p:blipFill>
          <a:blip r:embed="rId3">
            <a:alphaModFix amt="15000"/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607815" y="716407"/>
            <a:ext cx="5411343" cy="541134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734F9A8-3C9D-5CC0-0D51-3CB121E7706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522648" y="6185027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034950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1000"/>
                                  </p:stCondLst>
                                  <p:iterate type="lt"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4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nodeType="withEffect">
                                  <p:stCondLst>
                                    <p:cond delay="500"/>
                                  </p:stCondLst>
                                  <p:iterate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7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nodeType="withEffect">
                                  <p:stCondLst>
                                    <p:cond delay="500"/>
                                  </p:stCondLst>
                                  <p:iterate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7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>
            <a:extLst>
              <a:ext uri="{FF2B5EF4-FFF2-40B4-BE49-F238E27FC236}">
                <a16:creationId xmlns:a16="http://schemas.microsoft.com/office/drawing/2014/main" id="{F3060C83-F051-4F0E-ABAD-AA0DFC48B21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Freeform: Shape 10">
            <a:extLst>
              <a:ext uri="{FF2B5EF4-FFF2-40B4-BE49-F238E27FC236}">
                <a16:creationId xmlns:a16="http://schemas.microsoft.com/office/drawing/2014/main" id="{83C98ABE-055B-441F-B07E-44F97F083C3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8900000" flipH="1">
            <a:off x="-376156" y="-253670"/>
            <a:ext cx="1827638" cy="1376989"/>
          </a:xfrm>
          <a:custGeom>
            <a:avLst/>
            <a:gdLst>
              <a:gd name="connsiteX0" fmla="*/ 0 w 1827638"/>
              <a:gd name="connsiteY0" fmla="*/ 987379 h 1376989"/>
              <a:gd name="connsiteX1" fmla="*/ 987379 w 1827638"/>
              <a:gd name="connsiteY1" fmla="*/ 0 h 1376989"/>
              <a:gd name="connsiteX2" fmla="*/ 1827638 w 1827638"/>
              <a:gd name="connsiteY2" fmla="*/ 840260 h 1376989"/>
              <a:gd name="connsiteX3" fmla="*/ 1827638 w 1827638"/>
              <a:gd name="connsiteY3" fmla="*/ 1376989 h 1376989"/>
              <a:gd name="connsiteX4" fmla="*/ 0 w 1827638"/>
              <a:gd name="connsiteY4" fmla="*/ 1376989 h 13769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827638" h="1376989">
                <a:moveTo>
                  <a:pt x="0" y="987379"/>
                </a:moveTo>
                <a:lnTo>
                  <a:pt x="987379" y="0"/>
                </a:lnTo>
                <a:lnTo>
                  <a:pt x="1827638" y="840260"/>
                </a:lnTo>
                <a:lnTo>
                  <a:pt x="1827638" y="1376989"/>
                </a:lnTo>
                <a:lnTo>
                  <a:pt x="0" y="1376989"/>
                </a:lnTo>
                <a:close/>
              </a:path>
            </a:pathLst>
          </a:cu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29FDB030-9B49-4CED-8CCD-4D99382388A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8900000" flipH="1">
            <a:off x="891641" y="422146"/>
            <a:ext cx="645368" cy="645368"/>
          </a:xfrm>
          <a:prstGeom prst="rect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783CA14-24A1-485C-8B30-D6A5D87987A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8900000" flipH="1">
            <a:off x="10043482" y="655140"/>
            <a:ext cx="687472" cy="687472"/>
          </a:xfrm>
          <a:prstGeom prst="rect">
            <a:avLst/>
          </a:pr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Freeform: Shape 16">
            <a:extLst>
              <a:ext uri="{FF2B5EF4-FFF2-40B4-BE49-F238E27FC236}">
                <a16:creationId xmlns:a16="http://schemas.microsoft.com/office/drawing/2014/main" id="{9A97C86A-04D6-40F7-AE84-31AB43E6A84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0800000" flipH="1">
            <a:off x="9356643" y="0"/>
            <a:ext cx="2835357" cy="1480837"/>
          </a:xfrm>
          <a:custGeom>
            <a:avLst/>
            <a:gdLst>
              <a:gd name="connsiteX0" fmla="*/ 2835357 w 2835357"/>
              <a:gd name="connsiteY0" fmla="*/ 1480837 h 1480837"/>
              <a:gd name="connsiteX1" fmla="*/ 0 w 2835357"/>
              <a:gd name="connsiteY1" fmla="*/ 1480837 h 1480837"/>
              <a:gd name="connsiteX2" fmla="*/ 1552727 w 2835357"/>
              <a:gd name="connsiteY2" fmla="*/ 0 h 1480837"/>
              <a:gd name="connsiteX3" fmla="*/ 2835357 w 2835357"/>
              <a:gd name="connsiteY3" fmla="*/ 1223245 h 14808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835357" h="1480837">
                <a:moveTo>
                  <a:pt x="2835357" y="1480837"/>
                </a:moveTo>
                <a:lnTo>
                  <a:pt x="0" y="1480837"/>
                </a:lnTo>
                <a:lnTo>
                  <a:pt x="1552727" y="0"/>
                </a:lnTo>
                <a:lnTo>
                  <a:pt x="2835357" y="1223245"/>
                </a:lnTo>
                <a:close/>
              </a:path>
            </a:pathLst>
          </a:cu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19" name="Isosceles Triangle 18">
            <a:extLst>
              <a:ext uri="{FF2B5EF4-FFF2-40B4-BE49-F238E27FC236}">
                <a16:creationId xmlns:a16="http://schemas.microsoft.com/office/drawing/2014/main" id="{FF9F2414-84E8-453E-B1F3-389FDE8192D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flipH="1">
            <a:off x="7976344" y="6115501"/>
            <a:ext cx="1494513" cy="742499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 descr="A diagram of a route&#10;&#10;Description automatically generated">
            <a:extLst>
              <a:ext uri="{FF2B5EF4-FFF2-40B4-BE49-F238E27FC236}">
                <a16:creationId xmlns:a16="http://schemas.microsoft.com/office/drawing/2014/main" id="{BEAAE0BF-AC42-173F-8536-D128475AF7A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8466" y="-1"/>
            <a:ext cx="6269940" cy="6852397"/>
          </a:xfrm>
          <a:prstGeom prst="rect">
            <a:avLst/>
          </a:prstGeom>
          <a:ln>
            <a:noFill/>
          </a:ln>
        </p:spPr>
      </p:pic>
      <p:sp>
        <p:nvSpPr>
          <p:cNvPr id="21" name="Isosceles Triangle 20">
            <a:extLst>
              <a:ext uri="{FF2B5EF4-FFF2-40B4-BE49-F238E27FC236}">
                <a16:creationId xmlns:a16="http://schemas.microsoft.com/office/drawing/2014/main" id="{3ECA69A1-7536-43AC-85EF-C7106179F5E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flipH="1">
            <a:off x="7604080" y="6453143"/>
            <a:ext cx="814903" cy="404857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099F681-A981-C6A4-3F27-9770C2DC9747}"/>
              </a:ext>
            </a:extLst>
          </p:cNvPr>
          <p:cNvSpPr txBox="1"/>
          <p:nvPr/>
        </p:nvSpPr>
        <p:spPr>
          <a:xfrm>
            <a:off x="512150" y="2912012"/>
            <a:ext cx="3096568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/>
              <a:t>Race Overview</a:t>
            </a:r>
          </a:p>
        </p:txBody>
      </p:sp>
      <p:sp>
        <p:nvSpPr>
          <p:cNvPr id="6" name="Left Arrow 5">
            <a:extLst>
              <a:ext uri="{FF2B5EF4-FFF2-40B4-BE49-F238E27FC236}">
                <a16:creationId xmlns:a16="http://schemas.microsoft.com/office/drawing/2014/main" id="{995E02BA-B029-9BDA-50B8-85E1DD7C80A0}"/>
              </a:ext>
            </a:extLst>
          </p:cNvPr>
          <p:cNvSpPr/>
          <p:nvPr/>
        </p:nvSpPr>
        <p:spPr>
          <a:xfrm>
            <a:off x="7113319" y="998876"/>
            <a:ext cx="1284379" cy="202299"/>
          </a:xfrm>
          <a:prstGeom prst="leftArrow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BE2965C-E1EB-BA79-229A-3F429B1FE4CF}"/>
              </a:ext>
            </a:extLst>
          </p:cNvPr>
          <p:cNvSpPr txBox="1"/>
          <p:nvPr/>
        </p:nvSpPr>
        <p:spPr>
          <a:xfrm>
            <a:off x="8562355" y="-62953"/>
            <a:ext cx="1672113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/>
              <a:t>You are here</a:t>
            </a:r>
          </a:p>
        </p:txBody>
      </p:sp>
    </p:spTree>
    <p:extLst>
      <p:ext uri="{BB962C8B-B14F-4D97-AF65-F5344CB8AC3E}">
        <p14:creationId xmlns:p14="http://schemas.microsoft.com/office/powerpoint/2010/main" val="24305593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F231FB-0019-0512-1649-94C57D14FB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0"/>
            <a:ext cx="10515600" cy="1325563"/>
          </a:xfrm>
        </p:spPr>
        <p:txBody>
          <a:bodyPr>
            <a:normAutofit/>
          </a:bodyPr>
          <a:lstStyle/>
          <a:p>
            <a:r>
              <a:rPr lang="en-US" dirty="0"/>
              <a:t>Basic Rules</a:t>
            </a:r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FF073F82-F43D-3845-FD66-F62A9DC1AE0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774488390"/>
              </p:ext>
            </p:extLst>
          </p:nvPr>
        </p:nvGraphicFramePr>
        <p:xfrm>
          <a:off x="838200" y="1325563"/>
          <a:ext cx="10515600" cy="435133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1887716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53B021B3-DE93-4AB7-8A18-CF5F1CED88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075EA5A6-1487-908D-E2AB-77BC155330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42772" y="316992"/>
            <a:ext cx="10506456" cy="1014984"/>
          </a:xfrm>
        </p:spPr>
        <p:txBody>
          <a:bodyPr anchor="b">
            <a:normAutofit/>
          </a:bodyPr>
          <a:lstStyle/>
          <a:p>
            <a:r>
              <a:rPr lang="en-US" dirty="0"/>
              <a:t>Tips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2D502E5-F6B4-4D58-B4AE-FC466FF15EE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65953" y="1634502"/>
            <a:ext cx="10451592" cy="18288"/>
          </a:xfrm>
          <a:prstGeom prst="rect">
            <a:avLst/>
          </a:prstGeom>
          <a:solidFill>
            <a:srgbClr val="D5D5D5"/>
          </a:solidFill>
          <a:ln w="317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DECDBF4-02B6-4BB4-B65B-B8107AD6A9E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flipV="1">
            <a:off x="841248" y="1538176"/>
            <a:ext cx="1873457" cy="109814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128CD4B9-CF4C-B71F-9669-3EE6875E4FCE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54102069"/>
              </p:ext>
            </p:extLst>
          </p:nvPr>
        </p:nvGraphicFramePr>
        <p:xfrm>
          <a:off x="838200" y="1926266"/>
          <a:ext cx="10515600" cy="435752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35834417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Yellow question mark">
            <a:extLst>
              <a:ext uri="{FF2B5EF4-FFF2-40B4-BE49-F238E27FC236}">
                <a16:creationId xmlns:a16="http://schemas.microsoft.com/office/drawing/2014/main" id="{958F6545-67C9-BEB4-4581-68C14D7C84ED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</a:blip>
          <a:srcRect b="6250"/>
          <a:stretch/>
        </p:blipFill>
        <p:spPr>
          <a:xfrm>
            <a:off x="20" y="10"/>
            <a:ext cx="12191979" cy="6857990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EB0222B5-B739-82A9-5CCC-C5585AE12A6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4344663" y="-4344657"/>
            <a:ext cx="3512260" cy="12201589"/>
          </a:xfrm>
          <a:prstGeom prst="rect">
            <a:avLst/>
          </a:prstGeom>
          <a:gradFill flip="none" rotWithShape="1">
            <a:gsLst>
              <a:gs pos="10000">
                <a:srgbClr val="000000">
                  <a:alpha val="0"/>
                </a:srgbClr>
              </a:gs>
              <a:gs pos="66000">
                <a:srgbClr val="000000">
                  <a:alpha val="46000"/>
                </a:srgbClr>
              </a:gs>
              <a:gs pos="100000">
                <a:srgbClr val="000000">
                  <a:alpha val="60000"/>
                </a:srgbClr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1F106847-430A-25EA-E3A0-08D9826E8E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62000" y="1137434"/>
            <a:ext cx="7800660" cy="1520987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sz="4000">
                <a:solidFill>
                  <a:srgbClr val="FFFFFF"/>
                </a:solidFill>
              </a:rPr>
              <a:t>Questions?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5BE23E75-E7E9-4D9F-6D25-5512363F862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6200000">
            <a:off x="4878570" y="-449383"/>
            <a:ext cx="2425271" cy="12201588"/>
          </a:xfrm>
          <a:prstGeom prst="rect">
            <a:avLst/>
          </a:prstGeom>
          <a:gradFill flip="none" rotWithShape="1">
            <a:gsLst>
              <a:gs pos="10000">
                <a:srgbClr val="000000">
                  <a:alpha val="0"/>
                </a:srgbClr>
              </a:gs>
              <a:gs pos="66000">
                <a:srgbClr val="000000">
                  <a:alpha val="35000"/>
                </a:srgbClr>
              </a:gs>
              <a:gs pos="100000">
                <a:srgbClr val="000000">
                  <a:alpha val="45000"/>
                </a:srgbClr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61B115DB-65EB-3FC3-7284-CFDF4ADC60B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865140" y="871146"/>
            <a:ext cx="736939" cy="0"/>
          </a:xfrm>
          <a:prstGeom prst="line">
            <a:avLst/>
          </a:prstGeom>
          <a:ln w="5715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5611886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1000"/>
                                  </p:stCondLst>
                                  <p:iterate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7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208</Words>
  <Application>Microsoft Macintosh PowerPoint</Application>
  <PresentationFormat>Widescreen</PresentationFormat>
  <Paragraphs>14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Office Theme</vt:lpstr>
      <vt:lpstr>The EM-azing Race</vt:lpstr>
      <vt:lpstr>PowerPoint Presentation</vt:lpstr>
      <vt:lpstr>Basic Rules</vt:lpstr>
      <vt:lpstr>Tips</vt:lpstr>
      <vt:lpstr>Questions?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rendan Freeman</dc:creator>
  <cp:lastModifiedBy>Wray, Alisa</cp:lastModifiedBy>
  <cp:revision>2</cp:revision>
  <dcterms:created xsi:type="dcterms:W3CDTF">2024-09-05T02:48:46Z</dcterms:created>
  <dcterms:modified xsi:type="dcterms:W3CDTF">2025-10-27T21:29:48Z</dcterms:modified>
</cp:coreProperties>
</file>